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794500" cy="9906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246" autoAdjust="0"/>
    <p:restoredTop sz="65812" autoAdjust="0"/>
  </p:normalViewPr>
  <p:slideViewPr>
    <p:cSldViewPr>
      <p:cViewPr>
        <p:scale>
          <a:sx n="75" d="100"/>
          <a:sy n="75" d="100"/>
        </p:scale>
        <p:origin x="-2886" y="-29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0560814\Downloads\May%20files%20for%20stick%20300813\cue%20paper\c1%20all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0560814\Downloads\May%20files%20for%20stick%20300813\cue%20paper\c1%20all.xls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0560814\Downloads\May%20files%20for%20stick%20300813\cue%20paper\c2%20all.xls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0560814\Downloads\May%20files%20for%20stick%20300813\cue%20paper\c2%20all.xls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0560814\Downloads\May%20files%20for%20stick%20300813\cue%20paper\c2%20all.xls" TargetMode="External"/><Relationship Id="rId1" Type="http://schemas.openxmlformats.org/officeDocument/2006/relationships/themeOverride" Target="../theme/themeOverrid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48698513141585"/>
          <c:y val="0.30411715131875205"/>
          <c:w val="0.72915816026262292"/>
          <c:h val="0.51744838248288105"/>
        </c:manualLayout>
      </c:layout>
      <c:lineChart>
        <c:grouping val="standard"/>
        <c:varyColors val="0"/>
        <c:ser>
          <c:idx val="0"/>
          <c:order val="0"/>
          <c:tx>
            <c:strRef>
              <c:f>'retic dynamics'!$D$48</c:f>
              <c:strCache>
                <c:ptCount val="1"/>
                <c:pt idx="0">
                  <c:v>C</c:v>
                </c:pt>
              </c:strCache>
            </c:strRef>
          </c:tx>
          <c:spPr>
            <a:ln w="22225">
              <a:solidFill>
                <a:sysClr val="windowText" lastClr="00000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etic dynamics'!$F$62:$J$62</c:f>
                <c:numCache>
                  <c:formatCode>General</c:formatCode>
                  <c:ptCount val="5"/>
                  <c:pt idx="0">
                    <c:v>2.6914338186178805E-3</c:v>
                  </c:pt>
                  <c:pt idx="1">
                    <c:v>2.1085960163103809E-3</c:v>
                  </c:pt>
                  <c:pt idx="2">
                    <c:v>3.1008756601966503E-3</c:v>
                  </c:pt>
                  <c:pt idx="3">
                    <c:v>7.6629074160312494E-3</c:v>
                  </c:pt>
                  <c:pt idx="4">
                    <c:v>1.3549346316335701E-2</c:v>
                  </c:pt>
                </c:numCache>
              </c:numRef>
            </c:plus>
            <c:minus>
              <c:numRef>
                <c:f>'retic dynamics'!$F$62:$J$62</c:f>
                <c:numCache>
                  <c:formatCode>General</c:formatCode>
                  <c:ptCount val="5"/>
                  <c:pt idx="0">
                    <c:v>2.6914338186178805E-3</c:v>
                  </c:pt>
                  <c:pt idx="1">
                    <c:v>2.1085960163103809E-3</c:v>
                  </c:pt>
                  <c:pt idx="2">
                    <c:v>3.1008756601966503E-3</c:v>
                  </c:pt>
                  <c:pt idx="3">
                    <c:v>7.6629074160312494E-3</c:v>
                  </c:pt>
                  <c:pt idx="4">
                    <c:v>1.3549346316335701E-2</c:v>
                  </c:pt>
                </c:numCache>
              </c:numRef>
            </c:minus>
            <c:spPr>
              <a:ln w="3175">
                <a:solidFill>
                  <a:sysClr val="windowText" lastClr="000000"/>
                </a:solidFill>
                <a:prstDash val="solid"/>
              </a:ln>
            </c:spPr>
          </c:errBars>
          <c:cat>
            <c:numRef>
              <c:f>'retic dynamics'!$F$43:$I$43</c:f>
              <c:numCache>
                <c:formatCode>General</c:formatCode>
                <c:ptCount val="4"/>
                <c:pt idx="0">
                  <c:v>4</c:v>
                </c:pt>
                <c:pt idx="1">
                  <c:v>5</c:v>
                </c:pt>
                <c:pt idx="2">
                  <c:v>6</c:v>
                </c:pt>
                <c:pt idx="3">
                  <c:v>7</c:v>
                </c:pt>
              </c:numCache>
            </c:numRef>
          </c:cat>
          <c:val>
            <c:numRef>
              <c:f>'retic dynamics'!$F$48:$I$48</c:f>
              <c:numCache>
                <c:formatCode>General</c:formatCode>
                <c:ptCount val="4"/>
                <c:pt idx="0">
                  <c:v>1.6104000000000004E-2</c:v>
                </c:pt>
                <c:pt idx="1">
                  <c:v>1.6337399999999998E-2</c:v>
                </c:pt>
                <c:pt idx="2">
                  <c:v>1.9092600000000001E-2</c:v>
                </c:pt>
                <c:pt idx="3">
                  <c:v>2.7359666666666702E-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retic dynamics'!$D$49</c:f>
              <c:strCache>
                <c:ptCount val="1"/>
                <c:pt idx="0">
                  <c:v>U</c:v>
                </c:pt>
              </c:strCache>
            </c:strRef>
          </c:tx>
          <c:spPr>
            <a:ln w="22225">
              <a:solidFill>
                <a:srgbClr val="FF000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etic dynamics'!$F$63:$J$63</c:f>
                <c:numCache>
                  <c:formatCode>General</c:formatCode>
                  <c:ptCount val="5"/>
                  <c:pt idx="0">
                    <c:v>4.586998582951602E-3</c:v>
                  </c:pt>
                  <c:pt idx="1">
                    <c:v>1.55634081743042E-3</c:v>
                  </c:pt>
                  <c:pt idx="2">
                    <c:v>1.5175563449177103E-3</c:v>
                  </c:pt>
                  <c:pt idx="3">
                    <c:v>4.5129632726181208E-3</c:v>
                  </c:pt>
                  <c:pt idx="4">
                    <c:v>1.1338222962175298E-2</c:v>
                  </c:pt>
                </c:numCache>
              </c:numRef>
            </c:plus>
            <c:minus>
              <c:numRef>
                <c:f>'retic dynamics'!$F$63:$J$63</c:f>
                <c:numCache>
                  <c:formatCode>General</c:formatCode>
                  <c:ptCount val="5"/>
                  <c:pt idx="0">
                    <c:v>4.586998582951602E-3</c:v>
                  </c:pt>
                  <c:pt idx="1">
                    <c:v>1.55634081743042E-3</c:v>
                  </c:pt>
                  <c:pt idx="2">
                    <c:v>1.5175563449177103E-3</c:v>
                  </c:pt>
                  <c:pt idx="3">
                    <c:v>4.5129632726181208E-3</c:v>
                  </c:pt>
                  <c:pt idx="4">
                    <c:v>1.1338222962175298E-2</c:v>
                  </c:pt>
                </c:numCache>
              </c:numRef>
            </c:minus>
            <c:spPr>
              <a:ln w="3175">
                <a:solidFill>
                  <a:srgbClr val="FF0000"/>
                </a:solidFill>
                <a:prstDash val="solid"/>
              </a:ln>
            </c:spPr>
          </c:errBars>
          <c:cat>
            <c:numRef>
              <c:f>'retic dynamics'!$F$43:$I$43</c:f>
              <c:numCache>
                <c:formatCode>General</c:formatCode>
                <c:ptCount val="4"/>
                <c:pt idx="0">
                  <c:v>4</c:v>
                </c:pt>
                <c:pt idx="1">
                  <c:v>5</c:v>
                </c:pt>
                <c:pt idx="2">
                  <c:v>6</c:v>
                </c:pt>
                <c:pt idx="3">
                  <c:v>7</c:v>
                </c:pt>
              </c:numCache>
            </c:numRef>
          </c:cat>
          <c:val>
            <c:numRef>
              <c:f>'retic dynamics'!$F$49:$I$49</c:f>
              <c:numCache>
                <c:formatCode>General</c:formatCode>
                <c:ptCount val="4"/>
                <c:pt idx="0">
                  <c:v>2.0334000000000001E-2</c:v>
                </c:pt>
                <c:pt idx="1">
                  <c:v>1.9470200000000003E-2</c:v>
                </c:pt>
                <c:pt idx="2">
                  <c:v>2.0129399999999999E-2</c:v>
                </c:pt>
                <c:pt idx="3">
                  <c:v>2.7118E-2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retic dynamics'!$D$50</c:f>
              <c:strCache>
                <c:ptCount val="1"/>
                <c:pt idx="0">
                  <c:v>UL</c:v>
                </c:pt>
              </c:strCache>
            </c:strRef>
          </c:tx>
          <c:spPr>
            <a:ln w="22225">
              <a:solidFill>
                <a:srgbClr val="00B05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etic dynamics'!$F$64:$J$64</c:f>
                <c:numCache>
                  <c:formatCode>General</c:formatCode>
                  <c:ptCount val="5"/>
                  <c:pt idx="0">
                    <c:v>3.6474405638292004E-3</c:v>
                  </c:pt>
                  <c:pt idx="1">
                    <c:v>3.7012538579663913E-3</c:v>
                  </c:pt>
                  <c:pt idx="2">
                    <c:v>4.9966631115175332E-3</c:v>
                  </c:pt>
                  <c:pt idx="3">
                    <c:v>6.4686642380788308E-3</c:v>
                  </c:pt>
                  <c:pt idx="4">
                    <c:v>1.0962489784918605E-2</c:v>
                  </c:pt>
                </c:numCache>
              </c:numRef>
            </c:plus>
            <c:minus>
              <c:numRef>
                <c:f>'retic dynamics'!$F$64:$J$64</c:f>
                <c:numCache>
                  <c:formatCode>General</c:formatCode>
                  <c:ptCount val="5"/>
                  <c:pt idx="0">
                    <c:v>3.6474405638292004E-3</c:v>
                  </c:pt>
                  <c:pt idx="1">
                    <c:v>3.7012538579663913E-3</c:v>
                  </c:pt>
                  <c:pt idx="2">
                    <c:v>4.9966631115175332E-3</c:v>
                  </c:pt>
                  <c:pt idx="3">
                    <c:v>6.4686642380788308E-3</c:v>
                  </c:pt>
                  <c:pt idx="4">
                    <c:v>1.0962489784918605E-2</c:v>
                  </c:pt>
                </c:numCache>
              </c:numRef>
            </c:minus>
            <c:spPr>
              <a:ln w="3175">
                <a:solidFill>
                  <a:srgbClr val="00B050"/>
                </a:solidFill>
                <a:prstDash val="solid"/>
              </a:ln>
            </c:spPr>
          </c:errBars>
          <c:cat>
            <c:numRef>
              <c:f>'retic dynamics'!$F$43:$I$43</c:f>
              <c:numCache>
                <c:formatCode>General</c:formatCode>
                <c:ptCount val="4"/>
                <c:pt idx="0">
                  <c:v>4</c:v>
                </c:pt>
                <c:pt idx="1">
                  <c:v>5</c:v>
                </c:pt>
                <c:pt idx="2">
                  <c:v>6</c:v>
                </c:pt>
                <c:pt idx="3">
                  <c:v>7</c:v>
                </c:pt>
              </c:numCache>
            </c:numRef>
          </c:cat>
          <c:val>
            <c:numRef>
              <c:f>'retic dynamics'!$F$50:$I$50</c:f>
              <c:numCache>
                <c:formatCode>General</c:formatCode>
                <c:ptCount val="4"/>
                <c:pt idx="0">
                  <c:v>2.0264000000000001E-2</c:v>
                </c:pt>
                <c:pt idx="1">
                  <c:v>2.2539900000000005E-2</c:v>
                </c:pt>
                <c:pt idx="2">
                  <c:v>2.6011500000000003E-2</c:v>
                </c:pt>
                <c:pt idx="3">
                  <c:v>4.1911666666666701E-2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retic dynamics'!$D$51</c:f>
              <c:strCache>
                <c:ptCount val="1"/>
                <c:pt idx="0">
                  <c:v>AJ</c:v>
                </c:pt>
              </c:strCache>
            </c:strRef>
          </c:tx>
          <c:spPr>
            <a:ln w="22225">
              <a:solidFill>
                <a:srgbClr val="F79646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etic dynamics'!$F$65:$J$65</c:f>
                <c:numCache>
                  <c:formatCode>General</c:formatCode>
                  <c:ptCount val="5"/>
                  <c:pt idx="0">
                    <c:v>8.9193921068397711E-4</c:v>
                  </c:pt>
                  <c:pt idx="1">
                    <c:v>1.15072664048031E-3</c:v>
                  </c:pt>
                  <c:pt idx="2">
                    <c:v>2.5211213651424613E-3</c:v>
                  </c:pt>
                  <c:pt idx="3">
                    <c:v>3.6678386653601703E-3</c:v>
                  </c:pt>
                  <c:pt idx="4">
                    <c:v>8.8074132916538019E-3</c:v>
                  </c:pt>
                </c:numCache>
              </c:numRef>
            </c:plus>
            <c:minus>
              <c:numRef>
                <c:f>'retic dynamics'!$F$65:$J$65</c:f>
                <c:numCache>
                  <c:formatCode>General</c:formatCode>
                  <c:ptCount val="5"/>
                  <c:pt idx="0">
                    <c:v>8.9193921068397711E-4</c:v>
                  </c:pt>
                  <c:pt idx="1">
                    <c:v>1.15072664048031E-3</c:v>
                  </c:pt>
                  <c:pt idx="2">
                    <c:v>2.5211213651424613E-3</c:v>
                  </c:pt>
                  <c:pt idx="3">
                    <c:v>3.6678386653601703E-3</c:v>
                  </c:pt>
                  <c:pt idx="4">
                    <c:v>8.8074132916538019E-3</c:v>
                  </c:pt>
                </c:numCache>
              </c:numRef>
            </c:minus>
            <c:spPr>
              <a:ln w="3175">
                <a:solidFill>
                  <a:srgbClr val="7030A0"/>
                </a:solidFill>
                <a:prstDash val="solid"/>
              </a:ln>
            </c:spPr>
          </c:errBars>
          <c:cat>
            <c:numRef>
              <c:f>'retic dynamics'!$F$43:$I$43</c:f>
              <c:numCache>
                <c:formatCode>General</c:formatCode>
                <c:ptCount val="4"/>
                <c:pt idx="0">
                  <c:v>4</c:v>
                </c:pt>
                <c:pt idx="1">
                  <c:v>5</c:v>
                </c:pt>
                <c:pt idx="2">
                  <c:v>6</c:v>
                </c:pt>
                <c:pt idx="3">
                  <c:v>7</c:v>
                </c:pt>
              </c:numCache>
            </c:numRef>
          </c:cat>
          <c:val>
            <c:numRef>
              <c:f>'retic dynamics'!$F$51:$I$51</c:f>
              <c:numCache>
                <c:formatCode>General</c:formatCode>
                <c:ptCount val="4"/>
                <c:pt idx="0">
                  <c:v>1.4800000000000001E-2</c:v>
                </c:pt>
                <c:pt idx="1">
                  <c:v>1.9598700000000004E-2</c:v>
                </c:pt>
                <c:pt idx="2">
                  <c:v>2.3439600000000001E-2</c:v>
                </c:pt>
                <c:pt idx="3">
                  <c:v>2.7021011111111107E-2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retic dynamics'!$D$52</c:f>
              <c:strCache>
                <c:ptCount val="1"/>
                <c:pt idx="0">
                  <c:v>ER</c:v>
                </c:pt>
              </c:strCache>
            </c:strRef>
          </c:tx>
          <c:spPr>
            <a:ln w="22225">
              <a:solidFill>
                <a:srgbClr val="00B0F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etic dynamics'!$F$66:$J$66</c:f>
                <c:numCache>
                  <c:formatCode>General</c:formatCode>
                  <c:ptCount val="5"/>
                  <c:pt idx="0">
                    <c:v>2.373803792322451E-3</c:v>
                  </c:pt>
                  <c:pt idx="1">
                    <c:v>1.5527685672157804E-3</c:v>
                  </c:pt>
                  <c:pt idx="2">
                    <c:v>1.9236265949156204E-3</c:v>
                  </c:pt>
                  <c:pt idx="3">
                    <c:v>3.900006252487861E-3</c:v>
                  </c:pt>
                  <c:pt idx="4">
                    <c:v>1.3924672902162602E-2</c:v>
                  </c:pt>
                </c:numCache>
              </c:numRef>
            </c:plus>
            <c:minus>
              <c:numRef>
                <c:f>'retic dynamics'!$F$66:$J$66</c:f>
                <c:numCache>
                  <c:formatCode>General</c:formatCode>
                  <c:ptCount val="5"/>
                  <c:pt idx="0">
                    <c:v>2.373803792322451E-3</c:v>
                  </c:pt>
                  <c:pt idx="1">
                    <c:v>1.5527685672157804E-3</c:v>
                  </c:pt>
                  <c:pt idx="2">
                    <c:v>1.9236265949156204E-3</c:v>
                  </c:pt>
                  <c:pt idx="3">
                    <c:v>3.900006252487861E-3</c:v>
                  </c:pt>
                  <c:pt idx="4">
                    <c:v>1.3924672902162602E-2</c:v>
                  </c:pt>
                </c:numCache>
              </c:numRef>
            </c:minus>
            <c:spPr>
              <a:ln w="3175">
                <a:solidFill>
                  <a:srgbClr val="00B0F0"/>
                </a:solidFill>
                <a:prstDash val="solid"/>
              </a:ln>
            </c:spPr>
          </c:errBars>
          <c:cat>
            <c:numRef>
              <c:f>'retic dynamics'!$F$43:$I$43</c:f>
              <c:numCache>
                <c:formatCode>General</c:formatCode>
                <c:ptCount val="4"/>
                <c:pt idx="0">
                  <c:v>4</c:v>
                </c:pt>
                <c:pt idx="1">
                  <c:v>5</c:v>
                </c:pt>
                <c:pt idx="2">
                  <c:v>6</c:v>
                </c:pt>
                <c:pt idx="3">
                  <c:v>7</c:v>
                </c:pt>
              </c:numCache>
            </c:numRef>
          </c:cat>
          <c:val>
            <c:numRef>
              <c:f>'retic dynamics'!$F$52:$I$52</c:f>
              <c:numCache>
                <c:formatCode>General</c:formatCode>
                <c:ptCount val="4"/>
                <c:pt idx="0">
                  <c:v>2.1750000000000002E-2</c:v>
                </c:pt>
                <c:pt idx="1">
                  <c:v>2.0811699999999999E-2</c:v>
                </c:pt>
                <c:pt idx="2">
                  <c:v>2.0449100000000005E-2</c:v>
                </c:pt>
                <c:pt idx="3">
                  <c:v>3.1916777777777808E-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18387456"/>
        <c:axId val="118388992"/>
      </c:lineChart>
      <c:catAx>
        <c:axId val="1183874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118388992"/>
        <c:crosses val="autoZero"/>
        <c:auto val="1"/>
        <c:lblAlgn val="ctr"/>
        <c:lblOffset val="100"/>
        <c:noMultiLvlLbl val="0"/>
      </c:catAx>
      <c:valAx>
        <c:axId val="118388992"/>
        <c:scaling>
          <c:orientation val="minMax"/>
        </c:scaling>
        <c:delete val="0"/>
        <c:axPos val="l"/>
        <c:numFmt formatCode="#,##0.00" sourceLinked="0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118387456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 panose="020B0604020202020204" pitchFamily="34" charset="0"/>
          <a:ea typeface="Calibri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0936032574418102"/>
          <c:y val="8.8039864062431819E-2"/>
          <c:w val="0.82846348181665375"/>
          <c:h val="0.72886596765630995"/>
        </c:manualLayout>
      </c:layout>
      <c:lineChart>
        <c:grouping val="standard"/>
        <c:varyColors val="0"/>
        <c:ser>
          <c:idx val="0"/>
          <c:order val="0"/>
          <c:tx>
            <c:strRef>
              <c:f>'RBC density dynamics'!$A$45</c:f>
              <c:strCache>
                <c:ptCount val="1"/>
                <c:pt idx="0">
                  <c:v>C</c:v>
                </c:pt>
              </c:strCache>
            </c:strRef>
          </c:tx>
          <c:spPr>
            <a:ln w="22225">
              <a:solidFill>
                <a:sysClr val="windowText" lastClr="00000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BC density dynamics'!$E$57:$I$57</c:f>
                <c:numCache>
                  <c:formatCode>General</c:formatCode>
                  <c:ptCount val="5"/>
                  <c:pt idx="0">
                    <c:v>0.18242165441635499</c:v>
                  </c:pt>
                  <c:pt idx="1">
                    <c:v>0.14665708302022104</c:v>
                  </c:pt>
                  <c:pt idx="2">
                    <c:v>0.28713986139162206</c:v>
                  </c:pt>
                  <c:pt idx="3">
                    <c:v>0.96334711293489617</c:v>
                  </c:pt>
                  <c:pt idx="4">
                    <c:v>1.1704990346002002</c:v>
                  </c:pt>
                </c:numCache>
              </c:numRef>
            </c:plus>
            <c:minus>
              <c:numRef>
                <c:f>'RBC density dynamics'!$E$57:$I$57</c:f>
                <c:numCache>
                  <c:formatCode>General</c:formatCode>
                  <c:ptCount val="5"/>
                  <c:pt idx="0">
                    <c:v>0.18242165441635499</c:v>
                  </c:pt>
                  <c:pt idx="1">
                    <c:v>0.14665708302022104</c:v>
                  </c:pt>
                  <c:pt idx="2">
                    <c:v>0.28713986139162206</c:v>
                  </c:pt>
                  <c:pt idx="3">
                    <c:v>0.96334711293489617</c:v>
                  </c:pt>
                  <c:pt idx="4">
                    <c:v>1.1704990346002002</c:v>
                  </c:pt>
                </c:numCache>
              </c:numRef>
            </c:minus>
            <c:spPr>
              <a:ln w="3175">
                <a:solidFill>
                  <a:sysClr val="windowText" lastClr="000000"/>
                </a:solidFill>
                <a:prstDash val="solid"/>
              </a:ln>
            </c:spPr>
          </c:errBars>
          <c:cat>
            <c:numRef>
              <c:f>'RBC density dynamics'!$E$44:$H$44</c:f>
              <c:numCache>
                <c:formatCode>General</c:formatCode>
                <c:ptCount val="4"/>
                <c:pt idx="0">
                  <c:v>4</c:v>
                </c:pt>
                <c:pt idx="1">
                  <c:v>5</c:v>
                </c:pt>
                <c:pt idx="2">
                  <c:v>6</c:v>
                </c:pt>
                <c:pt idx="3">
                  <c:v>7</c:v>
                </c:pt>
              </c:numCache>
            </c:numRef>
          </c:cat>
          <c:val>
            <c:numRef>
              <c:f>'RBC density dynamics'!$E$45:$H$45</c:f>
              <c:numCache>
                <c:formatCode>General</c:formatCode>
                <c:ptCount val="4"/>
                <c:pt idx="0">
                  <c:v>8.6176000000000013</c:v>
                </c:pt>
                <c:pt idx="1">
                  <c:v>8.4810000000000034</c:v>
                </c:pt>
                <c:pt idx="2">
                  <c:v>7.8159999999999981</c:v>
                </c:pt>
                <c:pt idx="3">
                  <c:v>5.937400000000000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RBC density dynamics'!$A$46</c:f>
              <c:strCache>
                <c:ptCount val="1"/>
                <c:pt idx="0">
                  <c:v>U</c:v>
                </c:pt>
              </c:strCache>
            </c:strRef>
          </c:tx>
          <c:spPr>
            <a:ln w="22225">
              <a:solidFill>
                <a:srgbClr val="FF000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BC density dynamics'!$E$58:$I$58</c:f>
                <c:numCache>
                  <c:formatCode>General</c:formatCode>
                  <c:ptCount val="5"/>
                  <c:pt idx="0">
                    <c:v>0.21611520847301199</c:v>
                  </c:pt>
                  <c:pt idx="1">
                    <c:v>0.25679028408411392</c:v>
                  </c:pt>
                  <c:pt idx="2">
                    <c:v>0.38414743263491902</c:v>
                  </c:pt>
                  <c:pt idx="3">
                    <c:v>0.59154277106562581</c:v>
                  </c:pt>
                  <c:pt idx="4">
                    <c:v>0.57803356303938003</c:v>
                  </c:pt>
                </c:numCache>
              </c:numRef>
            </c:plus>
            <c:minus>
              <c:numRef>
                <c:f>'RBC density dynamics'!$E$58:$H$58</c:f>
                <c:numCache>
                  <c:formatCode>General</c:formatCode>
                  <c:ptCount val="4"/>
                  <c:pt idx="0">
                    <c:v>0.21611520847301199</c:v>
                  </c:pt>
                  <c:pt idx="1">
                    <c:v>0.25679028408411392</c:v>
                  </c:pt>
                  <c:pt idx="2">
                    <c:v>0.38414743263491902</c:v>
                  </c:pt>
                  <c:pt idx="3">
                    <c:v>0.59154277106562581</c:v>
                  </c:pt>
                </c:numCache>
              </c:numRef>
            </c:minus>
            <c:spPr>
              <a:ln w="6350">
                <a:solidFill>
                  <a:srgbClr val="FF0000"/>
                </a:solidFill>
                <a:prstDash val="solid"/>
              </a:ln>
            </c:spPr>
          </c:errBars>
          <c:cat>
            <c:numRef>
              <c:f>'RBC density dynamics'!$E$44:$H$44</c:f>
              <c:numCache>
                <c:formatCode>General</c:formatCode>
                <c:ptCount val="4"/>
                <c:pt idx="0">
                  <c:v>4</c:v>
                </c:pt>
                <c:pt idx="1">
                  <c:v>5</c:v>
                </c:pt>
                <c:pt idx="2">
                  <c:v>6</c:v>
                </c:pt>
                <c:pt idx="3">
                  <c:v>7</c:v>
                </c:pt>
              </c:numCache>
            </c:numRef>
          </c:cat>
          <c:val>
            <c:numRef>
              <c:f>'RBC density dynamics'!$E$46:$H$46</c:f>
              <c:numCache>
                <c:formatCode>General</c:formatCode>
                <c:ptCount val="4"/>
                <c:pt idx="0">
                  <c:v>8.918000000000001</c:v>
                </c:pt>
                <c:pt idx="1">
                  <c:v>8.680200000000001</c:v>
                </c:pt>
                <c:pt idx="2">
                  <c:v>8.104000000000001</c:v>
                </c:pt>
                <c:pt idx="3">
                  <c:v>5.7202000000000002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RBC density dynamics'!$A$47</c:f>
              <c:strCache>
                <c:ptCount val="1"/>
                <c:pt idx="0">
                  <c:v>UL</c:v>
                </c:pt>
              </c:strCache>
            </c:strRef>
          </c:tx>
          <c:spPr>
            <a:ln w="22225">
              <a:solidFill>
                <a:srgbClr val="00B05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BC density dynamics'!$E$59:$I$59</c:f>
                <c:numCache>
                  <c:formatCode>General</c:formatCode>
                  <c:ptCount val="5"/>
                  <c:pt idx="0">
                    <c:v>0.18533164267814001</c:v>
                  </c:pt>
                  <c:pt idx="1">
                    <c:v>0.19845668153137205</c:v>
                  </c:pt>
                  <c:pt idx="2">
                    <c:v>0.25764282985905007</c:v>
                  </c:pt>
                  <c:pt idx="3">
                    <c:v>0.28947937174635907</c:v>
                  </c:pt>
                  <c:pt idx="4">
                    <c:v>0.22630910277759603</c:v>
                  </c:pt>
                </c:numCache>
              </c:numRef>
            </c:plus>
            <c:minus>
              <c:numRef>
                <c:f>'RBC density dynamics'!$E$59:$I$59</c:f>
                <c:numCache>
                  <c:formatCode>General</c:formatCode>
                  <c:ptCount val="5"/>
                  <c:pt idx="0">
                    <c:v>0.18533164267814001</c:v>
                  </c:pt>
                  <c:pt idx="1">
                    <c:v>0.19845668153137205</c:v>
                  </c:pt>
                  <c:pt idx="2">
                    <c:v>0.25764282985905007</c:v>
                  </c:pt>
                  <c:pt idx="3">
                    <c:v>0.28947937174635907</c:v>
                  </c:pt>
                  <c:pt idx="4">
                    <c:v>0.22630910277759603</c:v>
                  </c:pt>
                </c:numCache>
              </c:numRef>
            </c:minus>
            <c:spPr>
              <a:ln w="3175">
                <a:solidFill>
                  <a:srgbClr val="00B050"/>
                </a:solidFill>
                <a:prstDash val="solid"/>
              </a:ln>
            </c:spPr>
          </c:errBars>
          <c:cat>
            <c:numRef>
              <c:f>'RBC density dynamics'!$E$44:$H$44</c:f>
              <c:numCache>
                <c:formatCode>General</c:formatCode>
                <c:ptCount val="4"/>
                <c:pt idx="0">
                  <c:v>4</c:v>
                </c:pt>
                <c:pt idx="1">
                  <c:v>5</c:v>
                </c:pt>
                <c:pt idx="2">
                  <c:v>6</c:v>
                </c:pt>
                <c:pt idx="3">
                  <c:v>7</c:v>
                </c:pt>
              </c:numCache>
            </c:numRef>
          </c:cat>
          <c:val>
            <c:numRef>
              <c:f>'RBC density dynamics'!$E$47:$H$47</c:f>
              <c:numCache>
                <c:formatCode>General</c:formatCode>
                <c:ptCount val="4"/>
                <c:pt idx="0">
                  <c:v>8.4088000000000012</c:v>
                </c:pt>
                <c:pt idx="1">
                  <c:v>8.5218999999999987</c:v>
                </c:pt>
                <c:pt idx="2">
                  <c:v>7.1234999999999964</c:v>
                </c:pt>
                <c:pt idx="3">
                  <c:v>4.8768000000000002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RBC density dynamics'!$A$48</c:f>
              <c:strCache>
                <c:ptCount val="1"/>
                <c:pt idx="0">
                  <c:v>AJ</c:v>
                </c:pt>
              </c:strCache>
            </c:strRef>
          </c:tx>
          <c:spPr>
            <a:ln w="22225">
              <a:solidFill>
                <a:srgbClr val="F79646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BC density dynamics'!$E$60:$I$60</c:f>
                <c:numCache>
                  <c:formatCode>General</c:formatCode>
                  <c:ptCount val="5"/>
                  <c:pt idx="0">
                    <c:v>0.157857775103078</c:v>
                  </c:pt>
                  <c:pt idx="1">
                    <c:v>0.19993687275342603</c:v>
                  </c:pt>
                  <c:pt idx="2">
                    <c:v>0.21014761860401399</c:v>
                  </c:pt>
                  <c:pt idx="3">
                    <c:v>0.33035110857733002</c:v>
                  </c:pt>
                  <c:pt idx="4">
                    <c:v>0.38209662018983304</c:v>
                  </c:pt>
                </c:numCache>
              </c:numRef>
            </c:plus>
            <c:minus>
              <c:numRef>
                <c:f>'RBC density dynamics'!$E$60:$I$60</c:f>
                <c:numCache>
                  <c:formatCode>General</c:formatCode>
                  <c:ptCount val="5"/>
                  <c:pt idx="0">
                    <c:v>0.157857775103078</c:v>
                  </c:pt>
                  <c:pt idx="1">
                    <c:v>0.19993687275342603</c:v>
                  </c:pt>
                  <c:pt idx="2">
                    <c:v>0.21014761860401399</c:v>
                  </c:pt>
                  <c:pt idx="3">
                    <c:v>0.33035110857733002</c:v>
                  </c:pt>
                  <c:pt idx="4">
                    <c:v>0.38209662018983304</c:v>
                  </c:pt>
                </c:numCache>
              </c:numRef>
            </c:minus>
            <c:spPr>
              <a:ln w="3175">
                <a:solidFill>
                  <a:srgbClr val="F79646"/>
                </a:solidFill>
                <a:prstDash val="solid"/>
              </a:ln>
            </c:spPr>
          </c:errBars>
          <c:cat>
            <c:numRef>
              <c:f>'RBC density dynamics'!$E$44:$H$44</c:f>
              <c:numCache>
                <c:formatCode>General</c:formatCode>
                <c:ptCount val="4"/>
                <c:pt idx="0">
                  <c:v>4</c:v>
                </c:pt>
                <c:pt idx="1">
                  <c:v>5</c:v>
                </c:pt>
                <c:pt idx="2">
                  <c:v>6</c:v>
                </c:pt>
                <c:pt idx="3">
                  <c:v>7</c:v>
                </c:pt>
              </c:numCache>
            </c:numRef>
          </c:cat>
          <c:val>
            <c:numRef>
              <c:f>'RBC density dynamics'!$E$48:$H$48</c:f>
              <c:numCache>
                <c:formatCode>General</c:formatCode>
                <c:ptCount val="4"/>
                <c:pt idx="0">
                  <c:v>8.7752222222222223</c:v>
                </c:pt>
                <c:pt idx="1">
                  <c:v>8.0975555555555552</c:v>
                </c:pt>
                <c:pt idx="2">
                  <c:v>7.1887777777777755</c:v>
                </c:pt>
                <c:pt idx="3">
                  <c:v>4.5562222222222228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RBC density dynamics'!$A$49</c:f>
              <c:strCache>
                <c:ptCount val="1"/>
                <c:pt idx="0">
                  <c:v>ER</c:v>
                </c:pt>
              </c:strCache>
            </c:strRef>
          </c:tx>
          <c:spPr>
            <a:ln w="22225">
              <a:solidFill>
                <a:srgbClr val="00B0F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BC density dynamics'!$E$61:$I$61</c:f>
                <c:numCache>
                  <c:formatCode>General</c:formatCode>
                  <c:ptCount val="5"/>
                  <c:pt idx="0">
                    <c:v>0.16770894099268799</c:v>
                  </c:pt>
                  <c:pt idx="1">
                    <c:v>0.15576786146913202</c:v>
                  </c:pt>
                  <c:pt idx="2">
                    <c:v>0.225075999510289</c:v>
                  </c:pt>
                  <c:pt idx="3">
                    <c:v>0.37905488315604613</c:v>
                  </c:pt>
                  <c:pt idx="4">
                    <c:v>0.21382187810314499</c:v>
                  </c:pt>
                </c:numCache>
              </c:numRef>
            </c:plus>
            <c:minus>
              <c:numRef>
                <c:f>'RBC density dynamics'!$E$61:$I$61</c:f>
                <c:numCache>
                  <c:formatCode>General</c:formatCode>
                  <c:ptCount val="5"/>
                  <c:pt idx="0">
                    <c:v>0.16770894099268799</c:v>
                  </c:pt>
                  <c:pt idx="1">
                    <c:v>0.15576786146913202</c:v>
                  </c:pt>
                  <c:pt idx="2">
                    <c:v>0.225075999510289</c:v>
                  </c:pt>
                  <c:pt idx="3">
                    <c:v>0.37905488315604613</c:v>
                  </c:pt>
                  <c:pt idx="4">
                    <c:v>0.21382187810314499</c:v>
                  </c:pt>
                </c:numCache>
              </c:numRef>
            </c:minus>
            <c:spPr>
              <a:ln w="3175">
                <a:solidFill>
                  <a:srgbClr val="00B0F0"/>
                </a:solidFill>
                <a:prstDash val="solid"/>
              </a:ln>
            </c:spPr>
          </c:errBars>
          <c:cat>
            <c:numRef>
              <c:f>'RBC density dynamics'!$E$44:$H$44</c:f>
              <c:numCache>
                <c:formatCode>General</c:formatCode>
                <c:ptCount val="4"/>
                <c:pt idx="0">
                  <c:v>4</c:v>
                </c:pt>
                <c:pt idx="1">
                  <c:v>5</c:v>
                </c:pt>
                <c:pt idx="2">
                  <c:v>6</c:v>
                </c:pt>
                <c:pt idx="3">
                  <c:v>7</c:v>
                </c:pt>
              </c:numCache>
            </c:numRef>
          </c:cat>
          <c:val>
            <c:numRef>
              <c:f>'RBC density dynamics'!$E$49:$H$49</c:f>
              <c:numCache>
                <c:formatCode>General</c:formatCode>
                <c:ptCount val="4"/>
                <c:pt idx="0">
                  <c:v>8.6830000000000016</c:v>
                </c:pt>
                <c:pt idx="1">
                  <c:v>8.4844000000000008</c:v>
                </c:pt>
                <c:pt idx="2">
                  <c:v>7.1964999999999986</c:v>
                </c:pt>
                <c:pt idx="3">
                  <c:v>4.698399999999999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18950528"/>
        <c:axId val="118976896"/>
      </c:lineChart>
      <c:catAx>
        <c:axId val="1189505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118976896"/>
        <c:crosses val="autoZero"/>
        <c:auto val="1"/>
        <c:lblAlgn val="ctr"/>
        <c:lblOffset val="100"/>
        <c:noMultiLvlLbl val="0"/>
      </c:catAx>
      <c:valAx>
        <c:axId val="118976896"/>
        <c:scaling>
          <c:orientation val="minMax"/>
        </c:scaling>
        <c:delete val="0"/>
        <c:axPos val="l"/>
        <c:numFmt formatCode="#,##0.00" sourceLinked="0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118950528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legend>
      <c:legendPos val="r"/>
      <c:layout>
        <c:manualLayout>
          <c:xMode val="edge"/>
          <c:yMode val="edge"/>
          <c:x val="0.28863111553501963"/>
          <c:y val="0.47414849157801242"/>
          <c:w val="0.21792383387509406"/>
          <c:h val="0.31352848829807611"/>
        </c:manualLayout>
      </c:layout>
      <c:overlay val="0"/>
      <c:spPr>
        <a:noFill/>
        <a:ln w="25400">
          <a:noFill/>
        </a:ln>
      </c:spPr>
    </c:legend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 panose="020B0604020202020204" pitchFamily="34" charset="0"/>
          <a:ea typeface="Calibri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09360433381798"/>
          <c:y val="6.5258882272621901E-2"/>
          <c:w val="0.85294634557915605"/>
          <c:h val="0.71064100457558133"/>
        </c:manualLayout>
      </c:layout>
      <c:lineChart>
        <c:grouping val="standard"/>
        <c:varyColors val="0"/>
        <c:ser>
          <c:idx val="0"/>
          <c:order val="0"/>
          <c:spPr>
            <a:ln w="22225">
              <a:solidFill>
                <a:sysClr val="windowText" lastClr="00000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BC density dynamics'!$H$56:$P$56</c:f>
                <c:numCache>
                  <c:formatCode>General</c:formatCode>
                  <c:ptCount val="9"/>
                  <c:pt idx="0">
                    <c:v>0.3709798646827081</c:v>
                  </c:pt>
                  <c:pt idx="1">
                    <c:v>0.29410481124932303</c:v>
                  </c:pt>
                  <c:pt idx="2">
                    <c:v>0.85853337879199487</c:v>
                  </c:pt>
                  <c:pt idx="3">
                    <c:v>0.75758527206146509</c:v>
                  </c:pt>
                  <c:pt idx="4">
                    <c:v>0.60431448766350115</c:v>
                  </c:pt>
                  <c:pt idx="5">
                    <c:v>0.46854823064914508</c:v>
                  </c:pt>
                  <c:pt idx="6">
                    <c:v>0.65901652314473902</c:v>
                  </c:pt>
                  <c:pt idx="7">
                    <c:v>1.103523598901869</c:v>
                  </c:pt>
                  <c:pt idx="8">
                    <c:v>0.68961833244516313</c:v>
                  </c:pt>
                </c:numCache>
              </c:numRef>
            </c:plus>
            <c:minus>
              <c:numRef>
                <c:f>'RBC density dynamics'!$H$56:$P$56</c:f>
                <c:numCache>
                  <c:formatCode>General</c:formatCode>
                  <c:ptCount val="9"/>
                  <c:pt idx="0">
                    <c:v>0.3709798646827081</c:v>
                  </c:pt>
                  <c:pt idx="1">
                    <c:v>0.29410481124932303</c:v>
                  </c:pt>
                  <c:pt idx="2">
                    <c:v>0.85853337879199487</c:v>
                  </c:pt>
                  <c:pt idx="3">
                    <c:v>0.75758527206146509</c:v>
                  </c:pt>
                  <c:pt idx="4">
                    <c:v>0.60431448766350115</c:v>
                  </c:pt>
                  <c:pt idx="5">
                    <c:v>0.46854823064914508</c:v>
                  </c:pt>
                  <c:pt idx="6">
                    <c:v>0.65901652314473902</c:v>
                  </c:pt>
                  <c:pt idx="7">
                    <c:v>1.103523598901869</c:v>
                  </c:pt>
                  <c:pt idx="8">
                    <c:v>0.68961833244516313</c:v>
                  </c:pt>
                </c:numCache>
              </c:numRef>
            </c:minus>
            <c:spPr>
              <a:ln w="3175">
                <a:solidFill>
                  <a:sysClr val="windowText" lastClr="000000"/>
                </a:solidFill>
                <a:prstDash val="solid"/>
              </a:ln>
            </c:spPr>
          </c:errBars>
          <c:cat>
            <c:numRef>
              <c:f>'RBC density dynamics'!$J$1:$M$1</c:f>
              <c:numCache>
                <c:formatCode>General</c:formatCode>
                <c:ptCount val="4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</c:numCache>
            </c:numRef>
          </c:cat>
          <c:val>
            <c:numRef>
              <c:f>'RBC density dynamics'!$J$44:$M$44</c:f>
              <c:numCache>
                <c:formatCode>0.0</c:formatCode>
                <c:ptCount val="4"/>
                <c:pt idx="0">
                  <c:v>2.7947500000000001</c:v>
                </c:pt>
                <c:pt idx="1">
                  <c:v>2.9106666666666654</c:v>
                </c:pt>
                <c:pt idx="2">
                  <c:v>3.1949999999999998</c:v>
                </c:pt>
                <c:pt idx="3">
                  <c:v>3.710666666666667</c:v>
                </c:pt>
              </c:numCache>
            </c:numRef>
          </c:val>
          <c:smooth val="0"/>
        </c:ser>
        <c:ser>
          <c:idx val="1"/>
          <c:order val="1"/>
          <c:spPr>
            <a:ln w="22225">
              <a:solidFill>
                <a:srgbClr val="FF000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BC density dynamics'!$H$57:$P$57</c:f>
                <c:numCache>
                  <c:formatCode>General</c:formatCode>
                  <c:ptCount val="9"/>
                  <c:pt idx="0">
                    <c:v>1.1928681046117384</c:v>
                  </c:pt>
                  <c:pt idx="1">
                    <c:v>1.1611847656596259</c:v>
                  </c:pt>
                  <c:pt idx="2">
                    <c:v>0.77657804501543704</c:v>
                  </c:pt>
                  <c:pt idx="3">
                    <c:v>0.37707585443780406</c:v>
                  </c:pt>
                  <c:pt idx="4">
                    <c:v>0.46311305315225004</c:v>
                  </c:pt>
                  <c:pt idx="5">
                    <c:v>0.56235519024901004</c:v>
                  </c:pt>
                  <c:pt idx="6">
                    <c:v>0.61526859175485193</c:v>
                  </c:pt>
                  <c:pt idx="7">
                    <c:v>0.67615922680977825</c:v>
                  </c:pt>
                  <c:pt idx="8">
                    <c:v>0.69023130905515884</c:v>
                  </c:pt>
                </c:numCache>
              </c:numRef>
            </c:plus>
            <c:minus>
              <c:numRef>
                <c:f>'RBC density dynamics'!$H$57:$P$57</c:f>
                <c:numCache>
                  <c:formatCode>General</c:formatCode>
                  <c:ptCount val="9"/>
                  <c:pt idx="0">
                    <c:v>1.1928681046117384</c:v>
                  </c:pt>
                  <c:pt idx="1">
                    <c:v>1.1611847656596259</c:v>
                  </c:pt>
                  <c:pt idx="2">
                    <c:v>0.77657804501543704</c:v>
                  </c:pt>
                  <c:pt idx="3">
                    <c:v>0.37707585443780406</c:v>
                  </c:pt>
                  <c:pt idx="4">
                    <c:v>0.46311305315225004</c:v>
                  </c:pt>
                  <c:pt idx="5">
                    <c:v>0.56235519024901004</c:v>
                  </c:pt>
                  <c:pt idx="6">
                    <c:v>0.61526859175485193</c:v>
                  </c:pt>
                  <c:pt idx="7">
                    <c:v>0.67615922680977825</c:v>
                  </c:pt>
                  <c:pt idx="8">
                    <c:v>0.69023130905515884</c:v>
                  </c:pt>
                </c:numCache>
              </c:numRef>
            </c:minus>
            <c:spPr>
              <a:ln w="3175">
                <a:solidFill>
                  <a:srgbClr val="FF0000"/>
                </a:solidFill>
                <a:prstDash val="solid"/>
              </a:ln>
            </c:spPr>
          </c:errBars>
          <c:cat>
            <c:numRef>
              <c:f>'RBC density dynamics'!$J$1:$M$1</c:f>
              <c:numCache>
                <c:formatCode>General</c:formatCode>
                <c:ptCount val="4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</c:numCache>
            </c:numRef>
          </c:cat>
          <c:val>
            <c:numRef>
              <c:f>'RBC density dynamics'!$J$45:$M$45</c:f>
              <c:numCache>
                <c:formatCode>0.0</c:formatCode>
                <c:ptCount val="4"/>
                <c:pt idx="0">
                  <c:v>3.4415999999999998</c:v>
                </c:pt>
                <c:pt idx="1">
                  <c:v>3.0489999999999999</c:v>
                </c:pt>
                <c:pt idx="2">
                  <c:v>3.3759999999999994</c:v>
                </c:pt>
                <c:pt idx="3">
                  <c:v>3.2816000000000001</c:v>
                </c:pt>
              </c:numCache>
            </c:numRef>
          </c:val>
          <c:smooth val="0"/>
        </c:ser>
        <c:ser>
          <c:idx val="2"/>
          <c:order val="2"/>
          <c:spPr>
            <a:ln w="22225">
              <a:solidFill>
                <a:srgbClr val="00B05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BC density dynamics'!$H$58:$P$58</c:f>
                <c:numCache>
                  <c:formatCode>General</c:formatCode>
                  <c:ptCount val="9"/>
                  <c:pt idx="0">
                    <c:v>0.55392691956811713</c:v>
                  </c:pt>
                  <c:pt idx="1">
                    <c:v>0.5828409409950539</c:v>
                  </c:pt>
                  <c:pt idx="2">
                    <c:v>0.28641359564073898</c:v>
                  </c:pt>
                  <c:pt idx="3">
                    <c:v>0.16170807029953696</c:v>
                  </c:pt>
                  <c:pt idx="4">
                    <c:v>0.35010112241803487</c:v>
                  </c:pt>
                  <c:pt idx="5">
                    <c:v>0.17388977273325898</c:v>
                  </c:pt>
                  <c:pt idx="6">
                    <c:v>0.13998413418358999</c:v>
                  </c:pt>
                  <c:pt idx="7">
                    <c:v>0.25592307251910701</c:v>
                  </c:pt>
                  <c:pt idx="8">
                    <c:v>0.35638521541824614</c:v>
                  </c:pt>
                </c:numCache>
              </c:numRef>
            </c:plus>
            <c:minus>
              <c:numRef>
                <c:f>'RBC density dynamics'!$H$58:$P$58</c:f>
                <c:numCache>
                  <c:formatCode>General</c:formatCode>
                  <c:ptCount val="9"/>
                  <c:pt idx="0">
                    <c:v>0.55392691956811713</c:v>
                  </c:pt>
                  <c:pt idx="1">
                    <c:v>0.5828409409950539</c:v>
                  </c:pt>
                  <c:pt idx="2">
                    <c:v>0.28641359564073898</c:v>
                  </c:pt>
                  <c:pt idx="3">
                    <c:v>0.16170807029953696</c:v>
                  </c:pt>
                  <c:pt idx="4">
                    <c:v>0.35010112241803487</c:v>
                  </c:pt>
                  <c:pt idx="5">
                    <c:v>0.17388977273325898</c:v>
                  </c:pt>
                  <c:pt idx="6">
                    <c:v>0.13998413418358999</c:v>
                  </c:pt>
                  <c:pt idx="7">
                    <c:v>0.25592307251910701</c:v>
                  </c:pt>
                  <c:pt idx="8">
                    <c:v>0.35638521541824614</c:v>
                  </c:pt>
                </c:numCache>
              </c:numRef>
            </c:minus>
            <c:spPr>
              <a:ln w="3175">
                <a:solidFill>
                  <a:srgbClr val="00B050"/>
                </a:solidFill>
                <a:prstDash val="solid"/>
              </a:ln>
            </c:spPr>
          </c:errBars>
          <c:cat>
            <c:numRef>
              <c:f>'RBC density dynamics'!$J$1:$M$1</c:f>
              <c:numCache>
                <c:formatCode>General</c:formatCode>
                <c:ptCount val="4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</c:numCache>
            </c:numRef>
          </c:cat>
          <c:val>
            <c:numRef>
              <c:f>'RBC density dynamics'!$J$46:$M$46</c:f>
              <c:numCache>
                <c:formatCode>0.0</c:formatCode>
                <c:ptCount val="4"/>
                <c:pt idx="0">
                  <c:v>2.4906249999999996</c:v>
                </c:pt>
                <c:pt idx="1">
                  <c:v>2.8875000000000002</c:v>
                </c:pt>
                <c:pt idx="2">
                  <c:v>3.8202857142857138</c:v>
                </c:pt>
                <c:pt idx="3">
                  <c:v>4.3787142857142864</c:v>
                </c:pt>
              </c:numCache>
            </c:numRef>
          </c:val>
          <c:smooth val="0"/>
        </c:ser>
        <c:ser>
          <c:idx val="3"/>
          <c:order val="3"/>
          <c:spPr>
            <a:ln w="22225">
              <a:solidFill>
                <a:srgbClr val="F79646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BC density dynamics'!$H$59:$P$59</c:f>
                <c:numCache>
                  <c:formatCode>General</c:formatCode>
                  <c:ptCount val="9"/>
                  <c:pt idx="0">
                    <c:v>0.27182007120724416</c:v>
                  </c:pt>
                  <c:pt idx="1">
                    <c:v>0.15298006809570999</c:v>
                  </c:pt>
                  <c:pt idx="2">
                    <c:v>0.20466278340410099</c:v>
                  </c:pt>
                  <c:pt idx="3">
                    <c:v>0.25202366226068107</c:v>
                  </c:pt>
                  <c:pt idx="4">
                    <c:v>0.40771111554812495</c:v>
                  </c:pt>
                  <c:pt idx="5">
                    <c:v>0.43348312429392205</c:v>
                  </c:pt>
                  <c:pt idx="6">
                    <c:v>0.39442838171120609</c:v>
                  </c:pt>
                  <c:pt idx="7">
                    <c:v>0.42313269657586705</c:v>
                  </c:pt>
                  <c:pt idx="8">
                    <c:v>0.42482773619689407</c:v>
                  </c:pt>
                </c:numCache>
              </c:numRef>
            </c:plus>
            <c:minus>
              <c:numRef>
                <c:f>'RBC density dynamics'!$H$59:$P$59</c:f>
                <c:numCache>
                  <c:formatCode>General</c:formatCode>
                  <c:ptCount val="9"/>
                  <c:pt idx="0">
                    <c:v>0.27182007120724416</c:v>
                  </c:pt>
                  <c:pt idx="1">
                    <c:v>0.15298006809570999</c:v>
                  </c:pt>
                  <c:pt idx="2">
                    <c:v>0.20466278340410099</c:v>
                  </c:pt>
                  <c:pt idx="3">
                    <c:v>0.25202366226068107</c:v>
                  </c:pt>
                  <c:pt idx="4">
                    <c:v>0.40771111554812495</c:v>
                  </c:pt>
                  <c:pt idx="5">
                    <c:v>0.43348312429392205</c:v>
                  </c:pt>
                  <c:pt idx="6">
                    <c:v>0.39442838171120609</c:v>
                  </c:pt>
                  <c:pt idx="7">
                    <c:v>0.42313269657586705</c:v>
                  </c:pt>
                  <c:pt idx="8">
                    <c:v>0.42482773619689407</c:v>
                  </c:pt>
                </c:numCache>
              </c:numRef>
            </c:minus>
            <c:spPr>
              <a:ln w="3175">
                <a:solidFill>
                  <a:srgbClr val="7030A0"/>
                </a:solidFill>
                <a:prstDash val="solid"/>
              </a:ln>
            </c:spPr>
          </c:errBars>
          <c:cat>
            <c:numRef>
              <c:f>'RBC density dynamics'!$J$1:$M$1</c:f>
              <c:numCache>
                <c:formatCode>General</c:formatCode>
                <c:ptCount val="4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</c:numCache>
            </c:numRef>
          </c:cat>
          <c:val>
            <c:numRef>
              <c:f>'RBC density dynamics'!$J$47:$M$47</c:f>
              <c:numCache>
                <c:formatCode>0.0</c:formatCode>
                <c:ptCount val="4"/>
                <c:pt idx="0">
                  <c:v>2.1363749999999997</c:v>
                </c:pt>
                <c:pt idx="1">
                  <c:v>2.5106249999999997</c:v>
                </c:pt>
                <c:pt idx="2">
                  <c:v>3.3171428571428581</c:v>
                </c:pt>
                <c:pt idx="3">
                  <c:v>3.6089999999999991</c:v>
                </c:pt>
              </c:numCache>
            </c:numRef>
          </c:val>
          <c:smooth val="0"/>
        </c:ser>
        <c:ser>
          <c:idx val="4"/>
          <c:order val="4"/>
          <c:spPr>
            <a:ln w="22225">
              <a:solidFill>
                <a:srgbClr val="00B0F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BC density dynamics'!$H$60:$P$60</c:f>
                <c:numCache>
                  <c:formatCode>General</c:formatCode>
                  <c:ptCount val="9"/>
                  <c:pt idx="0">
                    <c:v>0.55713530772255992</c:v>
                  </c:pt>
                  <c:pt idx="1">
                    <c:v>0.37568608021085609</c:v>
                  </c:pt>
                  <c:pt idx="2">
                    <c:v>0.28562825490486804</c:v>
                  </c:pt>
                  <c:pt idx="3">
                    <c:v>0.42799954701482806</c:v>
                  </c:pt>
                  <c:pt idx="4">
                    <c:v>0.54843951166850113</c:v>
                  </c:pt>
                  <c:pt idx="5">
                    <c:v>0.64110506212341822</c:v>
                  </c:pt>
                  <c:pt idx="6">
                    <c:v>0.78160036415785994</c:v>
                  </c:pt>
                  <c:pt idx="7">
                    <c:v>0.7558675692956569</c:v>
                  </c:pt>
                  <c:pt idx="8">
                    <c:v>0.56148399096398394</c:v>
                  </c:pt>
                </c:numCache>
              </c:numRef>
            </c:plus>
            <c:minus>
              <c:numRef>
                <c:f>'RBC density dynamics'!$H$60:$P$60</c:f>
                <c:numCache>
                  <c:formatCode>General</c:formatCode>
                  <c:ptCount val="9"/>
                  <c:pt idx="0">
                    <c:v>0.55713530772255992</c:v>
                  </c:pt>
                  <c:pt idx="1">
                    <c:v>0.37568608021085609</c:v>
                  </c:pt>
                  <c:pt idx="2">
                    <c:v>0.28562825490486804</c:v>
                  </c:pt>
                  <c:pt idx="3">
                    <c:v>0.42799954701482806</c:v>
                  </c:pt>
                  <c:pt idx="4">
                    <c:v>0.54843951166850113</c:v>
                  </c:pt>
                  <c:pt idx="5">
                    <c:v>0.64110506212341822</c:v>
                  </c:pt>
                  <c:pt idx="6">
                    <c:v>0.78160036415785994</c:v>
                  </c:pt>
                  <c:pt idx="7">
                    <c:v>0.7558675692956569</c:v>
                  </c:pt>
                  <c:pt idx="8">
                    <c:v>0.56148399096398394</c:v>
                  </c:pt>
                </c:numCache>
              </c:numRef>
            </c:minus>
            <c:spPr>
              <a:ln w="3175">
                <a:solidFill>
                  <a:srgbClr val="00B0F0"/>
                </a:solidFill>
                <a:prstDash val="solid"/>
              </a:ln>
            </c:spPr>
          </c:errBars>
          <c:cat>
            <c:numRef>
              <c:f>'RBC density dynamics'!$J$1:$M$1</c:f>
              <c:numCache>
                <c:formatCode>General</c:formatCode>
                <c:ptCount val="4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</c:numCache>
            </c:numRef>
          </c:cat>
          <c:val>
            <c:numRef>
              <c:f>'RBC density dynamics'!$J$48:$M$48</c:f>
              <c:numCache>
                <c:formatCode>0.0</c:formatCode>
                <c:ptCount val="4"/>
                <c:pt idx="0">
                  <c:v>1.9415</c:v>
                </c:pt>
                <c:pt idx="1">
                  <c:v>2.6354285714285721</c:v>
                </c:pt>
                <c:pt idx="2">
                  <c:v>2.9135714285714305</c:v>
                </c:pt>
                <c:pt idx="3">
                  <c:v>3.478285714285713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19018624"/>
        <c:axId val="119020160"/>
      </c:lineChart>
      <c:catAx>
        <c:axId val="1190186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119020160"/>
        <c:crosses val="autoZero"/>
        <c:auto val="1"/>
        <c:lblAlgn val="ctr"/>
        <c:lblOffset val="100"/>
        <c:noMultiLvlLbl val="0"/>
      </c:catAx>
      <c:valAx>
        <c:axId val="119020160"/>
        <c:scaling>
          <c:orientation val="minMax"/>
        </c:scaling>
        <c:delete val="0"/>
        <c:axPos val="l"/>
        <c:numFmt formatCode="0.00" sourceLinked="0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119018624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 panose="020B0604020202020204" pitchFamily="34" charset="0"/>
          <a:ea typeface="Calibri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41106821464282"/>
          <c:y val="6.3051661704416812E-2"/>
          <c:w val="0.77887123652927537"/>
          <c:h val="0.81882396644716304"/>
        </c:manualLayout>
      </c:layout>
      <c:lineChart>
        <c:grouping val="standard"/>
        <c:varyColors val="0"/>
        <c:ser>
          <c:idx val="0"/>
          <c:order val="0"/>
          <c:spPr>
            <a:ln w="22225">
              <a:solidFill>
                <a:sysClr val="windowText" lastClr="00000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Reticulocytaemia!$G$56:$K$56</c:f>
                <c:numCache>
                  <c:formatCode>General</c:formatCode>
                  <c:ptCount val="5"/>
                  <c:pt idx="0">
                    <c:v>4.3602150176338797E-2</c:v>
                  </c:pt>
                  <c:pt idx="1">
                    <c:v>2.4521487176216099E-2</c:v>
                  </c:pt>
                  <c:pt idx="2">
                    <c:v>3.4303417387258006E-2</c:v>
                  </c:pt>
                  <c:pt idx="3">
                    <c:v>1.2093524438034301E-2</c:v>
                  </c:pt>
                  <c:pt idx="4">
                    <c:v>1.1345532649951303E-2</c:v>
                  </c:pt>
                </c:numCache>
              </c:numRef>
            </c:plus>
            <c:minus>
              <c:numRef>
                <c:f>Reticulocytaemia!$G$56:$K$56</c:f>
                <c:numCache>
                  <c:formatCode>General</c:formatCode>
                  <c:ptCount val="5"/>
                  <c:pt idx="0">
                    <c:v>4.3602150176338797E-2</c:v>
                  </c:pt>
                  <c:pt idx="1">
                    <c:v>2.4521487176216099E-2</c:v>
                  </c:pt>
                  <c:pt idx="2">
                    <c:v>3.4303417387258006E-2</c:v>
                  </c:pt>
                  <c:pt idx="3">
                    <c:v>1.2093524438034301E-2</c:v>
                  </c:pt>
                  <c:pt idx="4">
                    <c:v>1.1345532649951303E-2</c:v>
                  </c:pt>
                </c:numCache>
              </c:numRef>
            </c:minus>
            <c:spPr>
              <a:ln w="3175">
                <a:solidFill>
                  <a:sysClr val="windowText" lastClr="000000"/>
                </a:solidFill>
              </a:ln>
            </c:spPr>
          </c:errBars>
          <c:cat>
            <c:numRef>
              <c:f>'RBC density dynamics'!$J$1:$M$1</c:f>
              <c:numCache>
                <c:formatCode>General</c:formatCode>
                <c:ptCount val="4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</c:numCache>
            </c:numRef>
          </c:cat>
          <c:val>
            <c:numRef>
              <c:f>Reticulocytaemia!$G$44:$J$44</c:f>
              <c:numCache>
                <c:formatCode>General</c:formatCode>
                <c:ptCount val="4"/>
                <c:pt idx="0">
                  <c:v>0.23014999999999999</c:v>
                </c:pt>
                <c:pt idx="1">
                  <c:v>0.2909000000000001</c:v>
                </c:pt>
                <c:pt idx="2">
                  <c:v>0.29553333333333293</c:v>
                </c:pt>
                <c:pt idx="3">
                  <c:v>0.17080000000000001</c:v>
                </c:pt>
              </c:numCache>
            </c:numRef>
          </c:val>
          <c:smooth val="0"/>
        </c:ser>
        <c:ser>
          <c:idx val="1"/>
          <c:order val="1"/>
          <c:spPr>
            <a:ln w="22225">
              <a:solidFill>
                <a:srgbClr val="FF000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Reticulocytaemia!$G$57:$K$57</c:f>
                <c:numCache>
                  <c:formatCode>General</c:formatCode>
                  <c:ptCount val="5"/>
                  <c:pt idx="0">
                    <c:v>5.8365292768905001E-2</c:v>
                  </c:pt>
                  <c:pt idx="1">
                    <c:v>6.8935934025731532E-2</c:v>
                  </c:pt>
                  <c:pt idx="2">
                    <c:v>3.4601583778781003E-2</c:v>
                  </c:pt>
                  <c:pt idx="3">
                    <c:v>3.0408906590010804E-2</c:v>
                  </c:pt>
                  <c:pt idx="4">
                    <c:v>3.133699730350701E-2</c:v>
                  </c:pt>
                </c:numCache>
              </c:numRef>
            </c:plus>
            <c:minus>
              <c:numRef>
                <c:f>Reticulocytaemia!$G$57:$K$57</c:f>
                <c:numCache>
                  <c:formatCode>General</c:formatCode>
                  <c:ptCount val="5"/>
                  <c:pt idx="0">
                    <c:v>5.8365292768905001E-2</c:v>
                  </c:pt>
                  <c:pt idx="1">
                    <c:v>6.8935934025731532E-2</c:v>
                  </c:pt>
                  <c:pt idx="2">
                    <c:v>3.4601583778781003E-2</c:v>
                  </c:pt>
                  <c:pt idx="3">
                    <c:v>3.0408906590010804E-2</c:v>
                  </c:pt>
                  <c:pt idx="4">
                    <c:v>3.133699730350701E-2</c:v>
                  </c:pt>
                </c:numCache>
              </c:numRef>
            </c:minus>
            <c:spPr>
              <a:ln w="6350">
                <a:solidFill>
                  <a:srgbClr val="FF0000"/>
                </a:solidFill>
              </a:ln>
            </c:spPr>
          </c:errBars>
          <c:cat>
            <c:numRef>
              <c:f>'RBC density dynamics'!$J$1:$M$1</c:f>
              <c:numCache>
                <c:formatCode>General</c:formatCode>
                <c:ptCount val="4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</c:numCache>
            </c:numRef>
          </c:cat>
          <c:val>
            <c:numRef>
              <c:f>Reticulocytaemia!$G$45:$J$45</c:f>
              <c:numCache>
                <c:formatCode>General</c:formatCode>
                <c:ptCount val="4"/>
                <c:pt idx="0">
                  <c:v>0.18608000000000002</c:v>
                </c:pt>
                <c:pt idx="1">
                  <c:v>0.25820000000000004</c:v>
                </c:pt>
                <c:pt idx="2">
                  <c:v>0.22866</c:v>
                </c:pt>
                <c:pt idx="3">
                  <c:v>0.19744000000000003</c:v>
                </c:pt>
              </c:numCache>
            </c:numRef>
          </c:val>
          <c:smooth val="0"/>
        </c:ser>
        <c:ser>
          <c:idx val="2"/>
          <c:order val="2"/>
          <c:spPr>
            <a:ln w="22225">
              <a:solidFill>
                <a:srgbClr val="00B05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Reticulocytaemia!$G$58:$K$58</c:f>
                <c:numCache>
                  <c:formatCode>General</c:formatCode>
                  <c:ptCount val="5"/>
                  <c:pt idx="0">
                    <c:v>3.3112260353444403E-2</c:v>
                  </c:pt>
                  <c:pt idx="1">
                    <c:v>3.1661308913922909E-2</c:v>
                  </c:pt>
                  <c:pt idx="2">
                    <c:v>1.7773011336652801E-2</c:v>
                  </c:pt>
                  <c:pt idx="3">
                    <c:v>2.5334954745820801E-2</c:v>
                  </c:pt>
                  <c:pt idx="4">
                    <c:v>9.0370100708368501E-3</c:v>
                  </c:pt>
                </c:numCache>
              </c:numRef>
            </c:plus>
            <c:minus>
              <c:numRef>
                <c:f>Reticulocytaemia!$G$58:$K$58</c:f>
                <c:numCache>
                  <c:formatCode>General</c:formatCode>
                  <c:ptCount val="5"/>
                  <c:pt idx="0">
                    <c:v>3.3112260353444403E-2</c:v>
                  </c:pt>
                  <c:pt idx="1">
                    <c:v>3.1661308913922909E-2</c:v>
                  </c:pt>
                  <c:pt idx="2">
                    <c:v>1.7773011336652801E-2</c:v>
                  </c:pt>
                  <c:pt idx="3">
                    <c:v>2.5334954745820801E-2</c:v>
                  </c:pt>
                  <c:pt idx="4">
                    <c:v>9.0370100708368501E-3</c:v>
                  </c:pt>
                </c:numCache>
              </c:numRef>
            </c:minus>
            <c:spPr>
              <a:ln w="3175">
                <a:solidFill>
                  <a:srgbClr val="00B050"/>
                </a:solidFill>
              </a:ln>
            </c:spPr>
          </c:errBars>
          <c:cat>
            <c:numRef>
              <c:f>'RBC density dynamics'!$J$1:$M$1</c:f>
              <c:numCache>
                <c:formatCode>General</c:formatCode>
                <c:ptCount val="4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</c:numCache>
            </c:numRef>
          </c:cat>
          <c:val>
            <c:numRef>
              <c:f>Reticulocytaemia!$G$46:$J$46</c:f>
              <c:numCache>
                <c:formatCode>General</c:formatCode>
                <c:ptCount val="4"/>
                <c:pt idx="0">
                  <c:v>0.19825000000000001</c:v>
                </c:pt>
                <c:pt idx="1">
                  <c:v>0.27917500000000001</c:v>
                </c:pt>
                <c:pt idx="2">
                  <c:v>0.28035714285714308</c:v>
                </c:pt>
                <c:pt idx="3">
                  <c:v>0.26214285714285707</c:v>
                </c:pt>
              </c:numCache>
            </c:numRef>
          </c:val>
          <c:smooth val="0"/>
        </c:ser>
        <c:ser>
          <c:idx val="3"/>
          <c:order val="3"/>
          <c:spPr>
            <a:ln w="22225">
              <a:solidFill>
                <a:srgbClr val="F79646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Reticulocytaemia!$G$59:$K$59</c:f>
                <c:numCache>
                  <c:formatCode>General</c:formatCode>
                  <c:ptCount val="5"/>
                  <c:pt idx="0">
                    <c:v>2.3590486410990794E-2</c:v>
                  </c:pt>
                  <c:pt idx="1">
                    <c:v>1.1044786059817704E-2</c:v>
                  </c:pt>
                  <c:pt idx="2">
                    <c:v>1.6525838354931904E-2</c:v>
                  </c:pt>
                  <c:pt idx="3">
                    <c:v>1.8142384695760905E-2</c:v>
                  </c:pt>
                  <c:pt idx="4">
                    <c:v>1.4902775616925705E-2</c:v>
                  </c:pt>
                </c:numCache>
              </c:numRef>
            </c:plus>
            <c:minus>
              <c:numRef>
                <c:f>Reticulocytaemia!$G$59:$K$59</c:f>
                <c:numCache>
                  <c:formatCode>General</c:formatCode>
                  <c:ptCount val="5"/>
                  <c:pt idx="0">
                    <c:v>2.3590486410990794E-2</c:v>
                  </c:pt>
                  <c:pt idx="1">
                    <c:v>1.1044786059817704E-2</c:v>
                  </c:pt>
                  <c:pt idx="2">
                    <c:v>1.6525838354931904E-2</c:v>
                  </c:pt>
                  <c:pt idx="3">
                    <c:v>1.8142384695760905E-2</c:v>
                  </c:pt>
                  <c:pt idx="4">
                    <c:v>1.4902775616925705E-2</c:v>
                  </c:pt>
                </c:numCache>
              </c:numRef>
            </c:minus>
            <c:spPr>
              <a:ln w="3175">
                <a:solidFill>
                  <a:srgbClr val="F79646"/>
                </a:solidFill>
              </a:ln>
            </c:spPr>
          </c:errBars>
          <c:cat>
            <c:numRef>
              <c:f>'RBC density dynamics'!$J$1:$M$1</c:f>
              <c:numCache>
                <c:formatCode>General</c:formatCode>
                <c:ptCount val="4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</c:numCache>
            </c:numRef>
          </c:cat>
          <c:val>
            <c:numRef>
              <c:f>Reticulocytaemia!$G$47:$J$47</c:f>
              <c:numCache>
                <c:formatCode>General</c:formatCode>
                <c:ptCount val="4"/>
                <c:pt idx="0">
                  <c:v>0.25763749999999996</c:v>
                </c:pt>
                <c:pt idx="1">
                  <c:v>0.2755125000000001</c:v>
                </c:pt>
                <c:pt idx="2">
                  <c:v>0.26779999999999998</c:v>
                </c:pt>
                <c:pt idx="3">
                  <c:v>0.20864285714285699</c:v>
                </c:pt>
              </c:numCache>
            </c:numRef>
          </c:val>
          <c:smooth val="0"/>
        </c:ser>
        <c:ser>
          <c:idx val="4"/>
          <c:order val="4"/>
          <c:spPr>
            <a:ln w="22225">
              <a:solidFill>
                <a:srgbClr val="00B0F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Reticulocytaemia!$G$60:$K$60</c:f>
                <c:numCache>
                  <c:formatCode>General</c:formatCode>
                  <c:ptCount val="5"/>
                  <c:pt idx="0">
                    <c:v>3.0015620933107501E-2</c:v>
                  </c:pt>
                  <c:pt idx="1">
                    <c:v>2.5208924291718195E-2</c:v>
                  </c:pt>
                  <c:pt idx="2">
                    <c:v>2.1924289949640692E-2</c:v>
                  </c:pt>
                  <c:pt idx="3">
                    <c:v>1.1861723154351501E-2</c:v>
                  </c:pt>
                  <c:pt idx="4">
                    <c:v>1.6804591209377506E-2</c:v>
                  </c:pt>
                </c:numCache>
              </c:numRef>
            </c:plus>
            <c:minus>
              <c:numRef>
                <c:f>Reticulocytaemia!$G$60:$K$60</c:f>
                <c:numCache>
                  <c:formatCode>General</c:formatCode>
                  <c:ptCount val="5"/>
                  <c:pt idx="0">
                    <c:v>3.0015620933107501E-2</c:v>
                  </c:pt>
                  <c:pt idx="1">
                    <c:v>2.5208924291718195E-2</c:v>
                  </c:pt>
                  <c:pt idx="2">
                    <c:v>2.1924289949640692E-2</c:v>
                  </c:pt>
                  <c:pt idx="3">
                    <c:v>1.1861723154351501E-2</c:v>
                  </c:pt>
                  <c:pt idx="4">
                    <c:v>1.6804591209377506E-2</c:v>
                  </c:pt>
                </c:numCache>
              </c:numRef>
            </c:minus>
            <c:spPr>
              <a:ln w="3175">
                <a:solidFill>
                  <a:srgbClr val="00B0F0"/>
                </a:solidFill>
              </a:ln>
            </c:spPr>
          </c:errBars>
          <c:cat>
            <c:numRef>
              <c:f>'RBC density dynamics'!$J$1:$M$1</c:f>
              <c:numCache>
                <c:formatCode>General</c:formatCode>
                <c:ptCount val="4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</c:numCache>
            </c:numRef>
          </c:cat>
          <c:val>
            <c:numRef>
              <c:f>Reticulocytaemia!$G$48:$J$48</c:f>
              <c:numCache>
                <c:formatCode>General</c:formatCode>
                <c:ptCount val="4"/>
                <c:pt idx="0">
                  <c:v>0.19309999999999999</c:v>
                </c:pt>
                <c:pt idx="1">
                  <c:v>0.30272857142857107</c:v>
                </c:pt>
                <c:pt idx="2">
                  <c:v>0.29938571428571403</c:v>
                </c:pt>
                <c:pt idx="3">
                  <c:v>0.2077000000000000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19073792"/>
        <c:axId val="119083776"/>
      </c:lineChart>
      <c:catAx>
        <c:axId val="1190737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119083776"/>
        <c:crosses val="autoZero"/>
        <c:auto val="1"/>
        <c:lblAlgn val="ctr"/>
        <c:lblOffset val="100"/>
        <c:noMultiLvlLbl val="0"/>
      </c:catAx>
      <c:valAx>
        <c:axId val="119083776"/>
        <c:scaling>
          <c:orientation val="minMax"/>
        </c:scaling>
        <c:delete val="0"/>
        <c:axPos val="l"/>
        <c:numFmt formatCode="#,##0.00" sourceLinked="0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119073792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 panose="020B0604020202020204" pitchFamily="34" charset="0"/>
          <a:ea typeface="Calibri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2083071467364902"/>
          <c:y val="0.12203546583158903"/>
          <c:w val="0.75668312841794794"/>
          <c:h val="0.72141919539533794"/>
        </c:manualLayout>
      </c:layout>
      <c:lineChart>
        <c:grouping val="standard"/>
        <c:varyColors val="0"/>
        <c:ser>
          <c:idx val="0"/>
          <c:order val="0"/>
          <c:tx>
            <c:strRef>
              <c:f>'asexual dynamics'!$AB$45</c:f>
              <c:strCache>
                <c:ptCount val="1"/>
                <c:pt idx="0">
                  <c:v>C</c:v>
                </c:pt>
              </c:strCache>
            </c:strRef>
          </c:tx>
          <c:spPr>
            <a:ln w="19050">
              <a:solidFill>
                <a:sysClr val="windowText" lastClr="00000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asexual dynamics'!$AN$52:$AQ$52</c:f>
                <c:numCache>
                  <c:formatCode>General</c:formatCode>
                  <c:ptCount val="4"/>
                  <c:pt idx="0">
                    <c:v>0.22783540213065401</c:v>
                  </c:pt>
                  <c:pt idx="1">
                    <c:v>0.292403899456323</c:v>
                  </c:pt>
                  <c:pt idx="2">
                    <c:v>0.23296640455571502</c:v>
                  </c:pt>
                  <c:pt idx="3">
                    <c:v>0.21924994999143907</c:v>
                  </c:pt>
                </c:numCache>
              </c:numRef>
            </c:plus>
            <c:minus>
              <c:numRef>
                <c:f>'asexual dynamics'!$AN$52:$AQ$52</c:f>
                <c:numCache>
                  <c:formatCode>General</c:formatCode>
                  <c:ptCount val="4"/>
                  <c:pt idx="0">
                    <c:v>0.22783540213065401</c:v>
                  </c:pt>
                  <c:pt idx="1">
                    <c:v>0.292403899456323</c:v>
                  </c:pt>
                  <c:pt idx="2">
                    <c:v>0.23296640455571502</c:v>
                  </c:pt>
                  <c:pt idx="3">
                    <c:v>0.21924994999143907</c:v>
                  </c:pt>
                </c:numCache>
              </c:numRef>
            </c:minus>
            <c:spPr>
              <a:ln w="3175">
                <a:solidFill>
                  <a:srgbClr val="002060"/>
                </a:solidFill>
              </a:ln>
            </c:spPr>
          </c:errBars>
          <c:cat>
            <c:numRef>
              <c:f>'asexual dynamics'!$AE$44:$AH$44</c:f>
              <c:numCache>
                <c:formatCode>General</c:formatCode>
                <c:ptCount val="4"/>
                <c:pt idx="0">
                  <c:v>4</c:v>
                </c:pt>
                <c:pt idx="1">
                  <c:v>5</c:v>
                </c:pt>
                <c:pt idx="2">
                  <c:v>6</c:v>
                </c:pt>
                <c:pt idx="3">
                  <c:v>7</c:v>
                </c:pt>
              </c:numCache>
            </c:numRef>
          </c:cat>
          <c:val>
            <c:numRef>
              <c:f>'asexual dynamics'!$AN$45:$AQ$45</c:f>
              <c:numCache>
                <c:formatCode>0.E+00</c:formatCode>
                <c:ptCount val="4"/>
                <c:pt idx="0">
                  <c:v>0.91072132141385209</c:v>
                </c:pt>
                <c:pt idx="1">
                  <c:v>1.9054005060768133</c:v>
                </c:pt>
                <c:pt idx="2">
                  <c:v>3.5180559870621555</c:v>
                </c:pt>
                <c:pt idx="3">
                  <c:v>5.11421097484361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asexual dynamics'!$AB$46</c:f>
              <c:strCache>
                <c:ptCount val="1"/>
                <c:pt idx="0">
                  <c:v>U</c:v>
                </c:pt>
              </c:strCache>
            </c:strRef>
          </c:tx>
          <c:spPr>
            <a:ln w="22225">
              <a:solidFill>
                <a:srgbClr val="FF000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asexual dynamics'!$AN$53:$AQ$53</c:f>
                <c:numCache>
                  <c:formatCode>General</c:formatCode>
                  <c:ptCount val="4"/>
                  <c:pt idx="0">
                    <c:v>0.186363770660917</c:v>
                  </c:pt>
                  <c:pt idx="1">
                    <c:v>0.19387238219193803</c:v>
                  </c:pt>
                  <c:pt idx="2">
                    <c:v>0.61679162867086923</c:v>
                  </c:pt>
                  <c:pt idx="3">
                    <c:v>0.55984434072580402</c:v>
                  </c:pt>
                </c:numCache>
              </c:numRef>
            </c:plus>
            <c:minus>
              <c:numRef>
                <c:f>'asexual dynamics'!$AN$53:$AQ$53</c:f>
                <c:numCache>
                  <c:formatCode>General</c:formatCode>
                  <c:ptCount val="4"/>
                  <c:pt idx="0">
                    <c:v>0.186363770660917</c:v>
                  </c:pt>
                  <c:pt idx="1">
                    <c:v>0.19387238219193803</c:v>
                  </c:pt>
                  <c:pt idx="2">
                    <c:v>0.61679162867086923</c:v>
                  </c:pt>
                  <c:pt idx="3">
                    <c:v>0.55984434072580402</c:v>
                  </c:pt>
                </c:numCache>
              </c:numRef>
            </c:minus>
            <c:spPr>
              <a:ln w="3175">
                <a:solidFill>
                  <a:srgbClr val="FF0000"/>
                </a:solidFill>
              </a:ln>
            </c:spPr>
          </c:errBars>
          <c:cat>
            <c:numRef>
              <c:f>'asexual dynamics'!$AE$44:$AH$44</c:f>
              <c:numCache>
                <c:formatCode>General</c:formatCode>
                <c:ptCount val="4"/>
                <c:pt idx="0">
                  <c:v>4</c:v>
                </c:pt>
                <c:pt idx="1">
                  <c:v>5</c:v>
                </c:pt>
                <c:pt idx="2">
                  <c:v>6</c:v>
                </c:pt>
                <c:pt idx="3">
                  <c:v>7</c:v>
                </c:pt>
              </c:numCache>
            </c:numRef>
          </c:cat>
          <c:val>
            <c:numRef>
              <c:f>'asexual dynamics'!$AN$46:$AQ$46</c:f>
              <c:numCache>
                <c:formatCode>0.E+00</c:formatCode>
                <c:ptCount val="4"/>
                <c:pt idx="0">
                  <c:v>0.70975026041567313</c:v>
                </c:pt>
                <c:pt idx="1">
                  <c:v>0.84965098695695396</c:v>
                </c:pt>
                <c:pt idx="2">
                  <c:v>2.9824913669410651</c:v>
                </c:pt>
                <c:pt idx="3">
                  <c:v>4.4558761630710064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asexual dynamics'!$AB$47</c:f>
              <c:strCache>
                <c:ptCount val="1"/>
                <c:pt idx="0">
                  <c:v>UL</c:v>
                </c:pt>
              </c:strCache>
            </c:strRef>
          </c:tx>
          <c:spPr>
            <a:ln w="22225">
              <a:solidFill>
                <a:srgbClr val="00B05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asexual dynamics'!$AN$54:$AQ$54</c:f>
                <c:numCache>
                  <c:formatCode>General</c:formatCode>
                  <c:ptCount val="4"/>
                  <c:pt idx="0">
                    <c:v>0.12567051369238694</c:v>
                  </c:pt>
                  <c:pt idx="1">
                    <c:v>0.229775819499317</c:v>
                  </c:pt>
                  <c:pt idx="2">
                    <c:v>0.62270163006312429</c:v>
                  </c:pt>
                  <c:pt idx="3">
                    <c:v>0.34843163566221702</c:v>
                  </c:pt>
                </c:numCache>
              </c:numRef>
            </c:plus>
            <c:minus>
              <c:numRef>
                <c:f>'asexual dynamics'!$AN$54:$AQ$54</c:f>
                <c:numCache>
                  <c:formatCode>General</c:formatCode>
                  <c:ptCount val="4"/>
                  <c:pt idx="0">
                    <c:v>0.12567051369238694</c:v>
                  </c:pt>
                  <c:pt idx="1">
                    <c:v>0.229775819499317</c:v>
                  </c:pt>
                  <c:pt idx="2">
                    <c:v>0.62270163006312429</c:v>
                  </c:pt>
                  <c:pt idx="3">
                    <c:v>0.34843163566221702</c:v>
                  </c:pt>
                </c:numCache>
              </c:numRef>
            </c:minus>
            <c:spPr>
              <a:ln w="3175">
                <a:solidFill>
                  <a:srgbClr val="00B050"/>
                </a:solidFill>
              </a:ln>
            </c:spPr>
          </c:errBars>
          <c:cat>
            <c:numRef>
              <c:f>'asexual dynamics'!$AE$44:$AH$44</c:f>
              <c:numCache>
                <c:formatCode>General</c:formatCode>
                <c:ptCount val="4"/>
                <c:pt idx="0">
                  <c:v>4</c:v>
                </c:pt>
                <c:pt idx="1">
                  <c:v>5</c:v>
                </c:pt>
                <c:pt idx="2">
                  <c:v>6</c:v>
                </c:pt>
                <c:pt idx="3">
                  <c:v>7</c:v>
                </c:pt>
              </c:numCache>
            </c:numRef>
          </c:cat>
          <c:val>
            <c:numRef>
              <c:f>'asexual dynamics'!$AN$47:$AQ$47</c:f>
              <c:numCache>
                <c:formatCode>0.E+00</c:formatCode>
                <c:ptCount val="4"/>
                <c:pt idx="0">
                  <c:v>0.96417572543210495</c:v>
                </c:pt>
                <c:pt idx="1">
                  <c:v>1.4437113487795976</c:v>
                </c:pt>
                <c:pt idx="2">
                  <c:v>4.4290389421830412</c:v>
                </c:pt>
                <c:pt idx="3">
                  <c:v>5.2977710895310102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asexual dynamics'!$AB$48</c:f>
              <c:strCache>
                <c:ptCount val="1"/>
                <c:pt idx="0">
                  <c:v>AJ</c:v>
                </c:pt>
              </c:strCache>
            </c:strRef>
          </c:tx>
          <c:spPr>
            <a:ln w="22225">
              <a:solidFill>
                <a:srgbClr val="F79646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asexual dynamics'!$AN$55:$AQ$55</c:f>
                <c:numCache>
                  <c:formatCode>General</c:formatCode>
                  <c:ptCount val="4"/>
                  <c:pt idx="0">
                    <c:v>0.13218883568856798</c:v>
                  </c:pt>
                  <c:pt idx="1">
                    <c:v>0.30534737302534504</c:v>
                  </c:pt>
                  <c:pt idx="2">
                    <c:v>0.54913758259145784</c:v>
                  </c:pt>
                  <c:pt idx="3">
                    <c:v>0.2868653732018101</c:v>
                  </c:pt>
                </c:numCache>
              </c:numRef>
            </c:plus>
            <c:minus>
              <c:numRef>
                <c:f>'asexual dynamics'!$AN$55:$AQ$55</c:f>
                <c:numCache>
                  <c:formatCode>General</c:formatCode>
                  <c:ptCount val="4"/>
                  <c:pt idx="0">
                    <c:v>0.13218883568856798</c:v>
                  </c:pt>
                  <c:pt idx="1">
                    <c:v>0.30534737302534504</c:v>
                  </c:pt>
                  <c:pt idx="2">
                    <c:v>0.54913758259145784</c:v>
                  </c:pt>
                  <c:pt idx="3">
                    <c:v>0.2868653732018101</c:v>
                  </c:pt>
                </c:numCache>
              </c:numRef>
            </c:minus>
            <c:spPr>
              <a:ln w="3175">
                <a:solidFill>
                  <a:srgbClr val="F79646"/>
                </a:solidFill>
              </a:ln>
            </c:spPr>
          </c:errBars>
          <c:cat>
            <c:numRef>
              <c:f>'asexual dynamics'!$AE$44:$AH$44</c:f>
              <c:numCache>
                <c:formatCode>General</c:formatCode>
                <c:ptCount val="4"/>
                <c:pt idx="0">
                  <c:v>4</c:v>
                </c:pt>
                <c:pt idx="1">
                  <c:v>5</c:v>
                </c:pt>
                <c:pt idx="2">
                  <c:v>6</c:v>
                </c:pt>
                <c:pt idx="3">
                  <c:v>7</c:v>
                </c:pt>
              </c:numCache>
            </c:numRef>
          </c:cat>
          <c:val>
            <c:numRef>
              <c:f>'asexual dynamics'!$AN$48:$AQ$48</c:f>
              <c:numCache>
                <c:formatCode>0.E+00</c:formatCode>
                <c:ptCount val="4"/>
                <c:pt idx="0">
                  <c:v>1.1142319587152449</c:v>
                </c:pt>
                <c:pt idx="1">
                  <c:v>1.4543608073234258</c:v>
                </c:pt>
                <c:pt idx="2">
                  <c:v>4.1583796802493227</c:v>
                </c:pt>
                <c:pt idx="3">
                  <c:v>4.400596751007126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asexual dynamics'!$AB$49</c:f>
              <c:strCache>
                <c:ptCount val="1"/>
                <c:pt idx="0">
                  <c:v>ER</c:v>
                </c:pt>
              </c:strCache>
            </c:strRef>
          </c:tx>
          <c:spPr>
            <a:ln w="22225">
              <a:solidFill>
                <a:srgbClr val="00B0F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asexual dynamics'!$AN$56:$AQ$56</c:f>
                <c:numCache>
                  <c:formatCode>General</c:formatCode>
                  <c:ptCount val="4"/>
                  <c:pt idx="0">
                    <c:v>0.22509533130147205</c:v>
                  </c:pt>
                  <c:pt idx="1">
                    <c:v>0.24790158638073004</c:v>
                  </c:pt>
                  <c:pt idx="2">
                    <c:v>0.44656771008038099</c:v>
                  </c:pt>
                  <c:pt idx="3">
                    <c:v>0.31675799463107002</c:v>
                  </c:pt>
                </c:numCache>
              </c:numRef>
            </c:plus>
            <c:minus>
              <c:numRef>
                <c:f>'asexual dynamics'!$AN$56:$AQ$56</c:f>
                <c:numCache>
                  <c:formatCode>General</c:formatCode>
                  <c:ptCount val="4"/>
                  <c:pt idx="0">
                    <c:v>0.22509533130147205</c:v>
                  </c:pt>
                  <c:pt idx="1">
                    <c:v>0.24790158638073004</c:v>
                  </c:pt>
                  <c:pt idx="2">
                    <c:v>0.44656771008038099</c:v>
                  </c:pt>
                  <c:pt idx="3">
                    <c:v>0.31675799463107002</c:v>
                  </c:pt>
                </c:numCache>
              </c:numRef>
            </c:minus>
            <c:spPr>
              <a:ln w="3175">
                <a:solidFill>
                  <a:srgbClr val="00B0F0"/>
                </a:solidFill>
              </a:ln>
            </c:spPr>
          </c:errBars>
          <c:cat>
            <c:numRef>
              <c:f>'asexual dynamics'!$AE$44:$AH$44</c:f>
              <c:numCache>
                <c:formatCode>General</c:formatCode>
                <c:ptCount val="4"/>
                <c:pt idx="0">
                  <c:v>4</c:v>
                </c:pt>
                <c:pt idx="1">
                  <c:v>5</c:v>
                </c:pt>
                <c:pt idx="2">
                  <c:v>6</c:v>
                </c:pt>
                <c:pt idx="3">
                  <c:v>7</c:v>
                </c:pt>
              </c:numCache>
            </c:numRef>
          </c:cat>
          <c:val>
            <c:numRef>
              <c:f>'asexual dynamics'!$AN$49:$AQ$49</c:f>
              <c:numCache>
                <c:formatCode>0.E+00</c:formatCode>
                <c:ptCount val="4"/>
                <c:pt idx="0">
                  <c:v>1.248489510119259</c:v>
                </c:pt>
                <c:pt idx="1">
                  <c:v>1.8709522762390971</c:v>
                </c:pt>
                <c:pt idx="2">
                  <c:v>3.9686392117526683</c:v>
                </c:pt>
                <c:pt idx="3">
                  <c:v>4.4152518552777202</c:v>
                </c:pt>
              </c:numCache>
            </c:numRef>
          </c:val>
          <c:smooth val="0"/>
        </c:ser>
        <c:ser>
          <c:idx val="5"/>
          <c:order val="5"/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asexual dynamics'!$AE$44:$AH$44</c:f>
              <c:numCache>
                <c:formatCode>General</c:formatCode>
                <c:ptCount val="4"/>
                <c:pt idx="0">
                  <c:v>4</c:v>
                </c:pt>
                <c:pt idx="1">
                  <c:v>5</c:v>
                </c:pt>
                <c:pt idx="2">
                  <c:v>6</c:v>
                </c:pt>
                <c:pt idx="3">
                  <c:v>7</c:v>
                </c:pt>
              </c:numCache>
            </c:numRef>
          </c:cat>
          <c:val>
            <c:numRef>
              <c:f>'asexual dynamics'!$AN$50:$AQ$50</c:f>
              <c:numCache>
                <c:formatCode>General</c:formatCode>
                <c:ptCount val="4"/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19138560"/>
        <c:axId val="119156736"/>
      </c:lineChart>
      <c:catAx>
        <c:axId val="1191385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119156736"/>
        <c:crosses val="autoZero"/>
        <c:auto val="1"/>
        <c:lblAlgn val="ctr"/>
        <c:lblOffset val="100"/>
        <c:noMultiLvlLbl val="0"/>
      </c:catAx>
      <c:valAx>
        <c:axId val="119156736"/>
        <c:scaling>
          <c:orientation val="minMax"/>
        </c:scaling>
        <c:delete val="0"/>
        <c:axPos val="l"/>
        <c:numFmt formatCode="#,##0.00" sourceLinked="0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119138560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 panose="020B0604020202020204" pitchFamily="34" charset="0"/>
          <a:ea typeface="Calibri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7427775709221799"/>
          <c:y val="0.14327350974634023"/>
          <c:w val="0.75727865673472816"/>
          <c:h val="0.72461712837415149"/>
        </c:manualLayout>
      </c:layout>
      <c:lineChart>
        <c:grouping val="standard"/>
        <c:varyColors val="0"/>
        <c:ser>
          <c:idx val="0"/>
          <c:order val="0"/>
          <c:tx>
            <c:strRef>
              <c:f>'asex dynamics'!$AL$43</c:f>
              <c:strCache>
                <c:ptCount val="1"/>
                <c:pt idx="0">
                  <c:v>C</c:v>
                </c:pt>
              </c:strCache>
            </c:strRef>
          </c:tx>
          <c:spPr>
            <a:ln w="22225">
              <a:solidFill>
                <a:sysClr val="windowText" lastClr="00000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asex dynamics'!$BG$55:$BJ$55</c:f>
                <c:numCache>
                  <c:formatCode>General</c:formatCode>
                  <c:ptCount val="4"/>
                  <c:pt idx="0">
                    <c:v>0.36066396693324904</c:v>
                  </c:pt>
                  <c:pt idx="1">
                    <c:v>0.25575632457871394</c:v>
                  </c:pt>
                  <c:pt idx="2">
                    <c:v>4.6583882262386793E-2</c:v>
                  </c:pt>
                  <c:pt idx="3">
                    <c:v>0.14462462868843398</c:v>
                  </c:pt>
                </c:numCache>
              </c:numRef>
            </c:plus>
            <c:minus>
              <c:numRef>
                <c:f>'asex dynamics'!$BG$55:$BJ$55</c:f>
                <c:numCache>
                  <c:formatCode>General</c:formatCode>
                  <c:ptCount val="4"/>
                  <c:pt idx="0">
                    <c:v>0.36066396693324904</c:v>
                  </c:pt>
                  <c:pt idx="1">
                    <c:v>0.25575632457871394</c:v>
                  </c:pt>
                  <c:pt idx="2">
                    <c:v>4.6583882262386793E-2</c:v>
                  </c:pt>
                  <c:pt idx="3">
                    <c:v>0.14462462868843398</c:v>
                  </c:pt>
                </c:numCache>
              </c:numRef>
            </c:minus>
            <c:spPr>
              <a:ln w="3175">
                <a:solidFill>
                  <a:sysClr val="windowText" lastClr="000000"/>
                </a:solidFill>
              </a:ln>
            </c:spPr>
          </c:errBars>
          <c:cat>
            <c:numRef>
              <c:f>'asex dynamics'!$BG$42:$BJ$42</c:f>
              <c:numCache>
                <c:formatCode>General</c:formatCode>
                <c:ptCount val="4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</c:numCache>
            </c:numRef>
          </c:cat>
          <c:val>
            <c:numRef>
              <c:f>'asex dynamics'!$BG$43:$BJ$43</c:f>
              <c:numCache>
                <c:formatCode>General</c:formatCode>
                <c:ptCount val="4"/>
                <c:pt idx="0">
                  <c:v>1.3162341193199159</c:v>
                </c:pt>
                <c:pt idx="1">
                  <c:v>0.51528020858764589</c:v>
                </c:pt>
                <c:pt idx="2">
                  <c:v>8.1182424736022996E-2</c:v>
                </c:pt>
                <c:pt idx="3">
                  <c:v>0.15688629293839101</c:v>
                </c:pt>
              </c:numCache>
            </c:numRef>
          </c:val>
          <c:smooth val="0"/>
        </c:ser>
        <c:ser>
          <c:idx val="4"/>
          <c:order val="1"/>
          <c:tx>
            <c:strRef>
              <c:f>'asex dynamics'!$AL$47</c:f>
              <c:strCache>
                <c:ptCount val="1"/>
                <c:pt idx="0">
                  <c:v>U</c:v>
                </c:pt>
              </c:strCache>
            </c:strRef>
          </c:tx>
          <c:spPr>
            <a:ln w="22225">
              <a:solidFill>
                <a:srgbClr val="FF000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asex dynamics'!$BG$59:$BJ$59</c:f>
                <c:numCache>
                  <c:formatCode>General</c:formatCode>
                  <c:ptCount val="4"/>
                  <c:pt idx="0">
                    <c:v>0.67241427626840722</c:v>
                  </c:pt>
                  <c:pt idx="1">
                    <c:v>1.7669751390315402</c:v>
                  </c:pt>
                  <c:pt idx="2">
                    <c:v>0.49556154819572601</c:v>
                  </c:pt>
                  <c:pt idx="3">
                    <c:v>0.61015517226651306</c:v>
                  </c:pt>
                </c:numCache>
              </c:numRef>
            </c:plus>
            <c:minus>
              <c:numRef>
                <c:f>'asex dynamics'!$BG$59:$BJ$59</c:f>
                <c:numCache>
                  <c:formatCode>General</c:formatCode>
                  <c:ptCount val="4"/>
                  <c:pt idx="0">
                    <c:v>0.67241427626840722</c:v>
                  </c:pt>
                  <c:pt idx="1">
                    <c:v>1.7669751390315402</c:v>
                  </c:pt>
                  <c:pt idx="2">
                    <c:v>0.49556154819572601</c:v>
                  </c:pt>
                  <c:pt idx="3">
                    <c:v>0.61015517226651306</c:v>
                  </c:pt>
                </c:numCache>
              </c:numRef>
            </c:minus>
            <c:spPr>
              <a:ln w="3175">
                <a:solidFill>
                  <a:srgbClr val="FF0000"/>
                </a:solidFill>
              </a:ln>
            </c:spPr>
          </c:errBars>
          <c:cat>
            <c:numRef>
              <c:f>'asex dynamics'!$BG$42:$BJ$42</c:f>
              <c:numCache>
                <c:formatCode>General</c:formatCode>
                <c:ptCount val="4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</c:numCache>
            </c:numRef>
          </c:cat>
          <c:val>
            <c:numRef>
              <c:f>'asex dynamics'!$BG$47:$BJ$47</c:f>
              <c:numCache>
                <c:formatCode>General</c:formatCode>
                <c:ptCount val="4"/>
                <c:pt idx="0">
                  <c:v>2.7160325465965274</c:v>
                </c:pt>
                <c:pt idx="1">
                  <c:v>2.1883774651527412</c:v>
                </c:pt>
                <c:pt idx="2">
                  <c:v>0.6135299127221111</c:v>
                </c:pt>
                <c:pt idx="3">
                  <c:v>0.62961612387299493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asex dynamics'!$AL$45</c:f>
              <c:strCache>
                <c:ptCount val="1"/>
                <c:pt idx="0">
                  <c:v>UL</c:v>
                </c:pt>
              </c:strCache>
            </c:strRef>
          </c:tx>
          <c:spPr>
            <a:ln w="22225">
              <a:solidFill>
                <a:srgbClr val="00B05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asex dynamics'!$BG$57:$BJ$57</c:f>
                <c:numCache>
                  <c:formatCode>General</c:formatCode>
                  <c:ptCount val="4"/>
                  <c:pt idx="0">
                    <c:v>0.18516957477138701</c:v>
                  </c:pt>
                  <c:pt idx="1">
                    <c:v>0.14014112111049104</c:v>
                  </c:pt>
                  <c:pt idx="2">
                    <c:v>5.7941738113830708E-2</c:v>
                  </c:pt>
                  <c:pt idx="3">
                    <c:v>2.1608206544477107E-2</c:v>
                  </c:pt>
                </c:numCache>
              </c:numRef>
            </c:plus>
            <c:minus>
              <c:numRef>
                <c:f>'asex dynamics'!$BG$57:$BJ$57</c:f>
                <c:numCache>
                  <c:formatCode>General</c:formatCode>
                  <c:ptCount val="4"/>
                  <c:pt idx="0">
                    <c:v>0.18516957477138701</c:v>
                  </c:pt>
                  <c:pt idx="1">
                    <c:v>0.14014112111049104</c:v>
                  </c:pt>
                  <c:pt idx="2">
                    <c:v>5.7941738113830708E-2</c:v>
                  </c:pt>
                  <c:pt idx="3">
                    <c:v>2.1608206544477107E-2</c:v>
                  </c:pt>
                </c:numCache>
              </c:numRef>
            </c:minus>
            <c:spPr>
              <a:ln>
                <a:solidFill>
                  <a:srgbClr val="00B050"/>
                </a:solidFill>
              </a:ln>
            </c:spPr>
          </c:errBars>
          <c:cat>
            <c:numRef>
              <c:f>'asex dynamics'!$BG$42:$BJ$42</c:f>
              <c:numCache>
                <c:formatCode>General</c:formatCode>
                <c:ptCount val="4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</c:numCache>
            </c:numRef>
          </c:cat>
          <c:val>
            <c:numRef>
              <c:f>'asex dynamics'!$BG$45:$BJ$45</c:f>
              <c:numCache>
                <c:formatCode>General</c:formatCode>
                <c:ptCount val="4"/>
                <c:pt idx="0">
                  <c:v>1.4092702753841866</c:v>
                </c:pt>
                <c:pt idx="1">
                  <c:v>0.433399536526203</c:v>
                </c:pt>
                <c:pt idx="2">
                  <c:v>0.141957070499659</c:v>
                </c:pt>
                <c:pt idx="3">
                  <c:v>4.6550383168458886E-2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asex dynamics'!$AL$46</c:f>
              <c:strCache>
                <c:ptCount val="1"/>
                <c:pt idx="0">
                  <c:v>AJ</c:v>
                </c:pt>
              </c:strCache>
            </c:strRef>
          </c:tx>
          <c:spPr>
            <a:ln w="22225">
              <a:solidFill>
                <a:srgbClr val="F79646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asex dynamics'!$BG$58:$BJ$58</c:f>
                <c:numCache>
                  <c:formatCode>General</c:formatCode>
                  <c:ptCount val="4"/>
                  <c:pt idx="0">
                    <c:v>0.61588033099521999</c:v>
                  </c:pt>
                  <c:pt idx="1">
                    <c:v>0.37051406112789309</c:v>
                  </c:pt>
                  <c:pt idx="2">
                    <c:v>9.6115015073702806E-2</c:v>
                  </c:pt>
                  <c:pt idx="3">
                    <c:v>4.1586903712482991E-2</c:v>
                  </c:pt>
                </c:numCache>
              </c:numRef>
            </c:plus>
            <c:minus>
              <c:numRef>
                <c:f>'asex dynamics'!$BG$58:$BJ$58</c:f>
                <c:numCache>
                  <c:formatCode>General</c:formatCode>
                  <c:ptCount val="4"/>
                  <c:pt idx="0">
                    <c:v>0.61588033099521999</c:v>
                  </c:pt>
                  <c:pt idx="1">
                    <c:v>0.37051406112789309</c:v>
                  </c:pt>
                  <c:pt idx="2">
                    <c:v>9.6115015073702806E-2</c:v>
                  </c:pt>
                  <c:pt idx="3">
                    <c:v>4.1586903712482991E-2</c:v>
                  </c:pt>
                </c:numCache>
              </c:numRef>
            </c:minus>
            <c:spPr>
              <a:ln w="3175">
                <a:solidFill>
                  <a:srgbClr val="F79646"/>
                </a:solidFill>
              </a:ln>
            </c:spPr>
          </c:errBars>
          <c:cat>
            <c:numRef>
              <c:f>'asex dynamics'!$BG$42:$BJ$42</c:f>
              <c:numCache>
                <c:formatCode>General</c:formatCode>
                <c:ptCount val="4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</c:numCache>
            </c:numRef>
          </c:cat>
          <c:val>
            <c:numRef>
              <c:f>'asex dynamics'!$BG$46:$BJ$46</c:f>
              <c:numCache>
                <c:formatCode>General</c:formatCode>
                <c:ptCount val="4"/>
                <c:pt idx="0">
                  <c:v>1.8666058296032255</c:v>
                </c:pt>
                <c:pt idx="1">
                  <c:v>0.443441834193468</c:v>
                </c:pt>
                <c:pt idx="2">
                  <c:v>0.12170154173033602</c:v>
                </c:pt>
                <c:pt idx="3">
                  <c:v>6.7709628897053911E-2</c:v>
                </c:pt>
              </c:numCache>
            </c:numRef>
          </c:val>
          <c:smooth val="0"/>
        </c:ser>
        <c:ser>
          <c:idx val="1"/>
          <c:order val="4"/>
          <c:tx>
            <c:strRef>
              <c:f>'asex dynamics'!$AL$44</c:f>
              <c:strCache>
                <c:ptCount val="1"/>
                <c:pt idx="0">
                  <c:v>ER</c:v>
                </c:pt>
              </c:strCache>
            </c:strRef>
          </c:tx>
          <c:spPr>
            <a:ln w="22225">
              <a:solidFill>
                <a:srgbClr val="00B0F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asex dynamics'!$BG$56:$BJ$56</c:f>
                <c:numCache>
                  <c:formatCode>General</c:formatCode>
                  <c:ptCount val="4"/>
                  <c:pt idx="0">
                    <c:v>0.89014230484745083</c:v>
                  </c:pt>
                  <c:pt idx="1">
                    <c:v>0.64506892245860914</c:v>
                  </c:pt>
                  <c:pt idx="2">
                    <c:v>5.098509807603821E-2</c:v>
                  </c:pt>
                  <c:pt idx="3">
                    <c:v>0.115342153623493</c:v>
                  </c:pt>
                </c:numCache>
              </c:numRef>
            </c:plus>
            <c:minus>
              <c:numRef>
                <c:f>'asex dynamics'!$BG$56:$BJ$56</c:f>
                <c:numCache>
                  <c:formatCode>General</c:formatCode>
                  <c:ptCount val="4"/>
                  <c:pt idx="0">
                    <c:v>0.89014230484745083</c:v>
                  </c:pt>
                  <c:pt idx="1">
                    <c:v>0.64506892245860914</c:v>
                  </c:pt>
                  <c:pt idx="2">
                    <c:v>5.098509807603821E-2</c:v>
                  </c:pt>
                  <c:pt idx="3">
                    <c:v>0.115342153623493</c:v>
                  </c:pt>
                </c:numCache>
              </c:numRef>
            </c:minus>
            <c:spPr>
              <a:ln w="3175">
                <a:solidFill>
                  <a:srgbClr val="00B0F0"/>
                </a:solidFill>
              </a:ln>
            </c:spPr>
          </c:errBars>
          <c:cat>
            <c:numRef>
              <c:f>'asex dynamics'!$BG$42:$BJ$42</c:f>
              <c:numCache>
                <c:formatCode>General</c:formatCode>
                <c:ptCount val="4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</c:numCache>
            </c:numRef>
          </c:cat>
          <c:val>
            <c:numRef>
              <c:f>'asex dynamics'!$BG$44:$BJ$44</c:f>
              <c:numCache>
                <c:formatCode>General</c:formatCode>
                <c:ptCount val="4"/>
                <c:pt idx="0">
                  <c:v>2.1125127346856245</c:v>
                </c:pt>
                <c:pt idx="1">
                  <c:v>0.82814223249724905</c:v>
                </c:pt>
                <c:pt idx="2">
                  <c:v>7.962597459724971E-2</c:v>
                </c:pt>
                <c:pt idx="3">
                  <c:v>0.1542953595740450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0025472"/>
        <c:axId val="120027008"/>
      </c:lineChart>
      <c:catAx>
        <c:axId val="1200254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120027008"/>
        <c:crosses val="autoZero"/>
        <c:auto val="1"/>
        <c:lblAlgn val="ctr"/>
        <c:lblOffset val="100"/>
        <c:noMultiLvlLbl val="0"/>
      </c:catAx>
      <c:valAx>
        <c:axId val="120027008"/>
        <c:scaling>
          <c:orientation val="minMax"/>
          <c:max val="6"/>
        </c:scaling>
        <c:delete val="0"/>
        <c:axPos val="l"/>
        <c:numFmt formatCode="#,##0.00" sourceLinked="0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120025472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 panose="020B0604020202020204" pitchFamily="34" charset="0"/>
          <a:ea typeface="Calibri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40F52B-4960-0D4C-BD05-B8797214ABE2}" type="datetimeFigureOut">
              <a:rPr lang="en-US" smtClean="0"/>
              <a:pPr/>
              <a:t>11/29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5013" y="742950"/>
            <a:ext cx="2784475" cy="3714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05350"/>
            <a:ext cx="5435600" cy="44577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08981"/>
            <a:ext cx="294428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8645" y="9408981"/>
            <a:ext cx="294428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EA3E03-A781-F248-8A22-7A0AF445F5D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8522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sz="1200" b="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6EA3E03-A781-F248-8A22-7A0AF445F5D2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63178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148D7-0B0B-4291-9BEB-1FB0E4031039}" type="datetimeFigureOut">
              <a:rPr lang="en-GB" smtClean="0"/>
              <a:pPr/>
              <a:t>29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BA5C5-F6EF-4BDB-9F97-4E8AB2022E6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4787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148D7-0B0B-4291-9BEB-1FB0E4031039}" type="datetimeFigureOut">
              <a:rPr lang="en-GB" smtClean="0"/>
              <a:pPr/>
              <a:t>29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BA5C5-F6EF-4BDB-9F97-4E8AB2022E6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03771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148D7-0B0B-4291-9BEB-1FB0E4031039}" type="datetimeFigureOut">
              <a:rPr lang="en-GB" smtClean="0"/>
              <a:pPr/>
              <a:t>29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BA5C5-F6EF-4BDB-9F97-4E8AB2022E6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92077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148D7-0B0B-4291-9BEB-1FB0E4031039}" type="datetimeFigureOut">
              <a:rPr lang="en-GB" smtClean="0"/>
              <a:pPr/>
              <a:t>29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BA5C5-F6EF-4BDB-9F97-4E8AB2022E6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496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148D7-0B0B-4291-9BEB-1FB0E4031039}" type="datetimeFigureOut">
              <a:rPr lang="en-GB" smtClean="0"/>
              <a:pPr/>
              <a:t>29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BA5C5-F6EF-4BDB-9F97-4E8AB2022E6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9149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148D7-0B0B-4291-9BEB-1FB0E4031039}" type="datetimeFigureOut">
              <a:rPr lang="en-GB" smtClean="0"/>
              <a:pPr/>
              <a:t>29/1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BA5C5-F6EF-4BDB-9F97-4E8AB2022E6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8138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148D7-0B0B-4291-9BEB-1FB0E4031039}" type="datetimeFigureOut">
              <a:rPr lang="en-GB" smtClean="0"/>
              <a:pPr/>
              <a:t>29/11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BA5C5-F6EF-4BDB-9F97-4E8AB2022E6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2681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148D7-0B0B-4291-9BEB-1FB0E4031039}" type="datetimeFigureOut">
              <a:rPr lang="en-GB" smtClean="0"/>
              <a:pPr/>
              <a:t>29/11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BA5C5-F6EF-4BDB-9F97-4E8AB2022E6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1861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148D7-0B0B-4291-9BEB-1FB0E4031039}" type="datetimeFigureOut">
              <a:rPr lang="en-GB" smtClean="0"/>
              <a:pPr/>
              <a:t>29/11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BA5C5-F6EF-4BDB-9F97-4E8AB2022E6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4995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148D7-0B0B-4291-9BEB-1FB0E4031039}" type="datetimeFigureOut">
              <a:rPr lang="en-GB" smtClean="0"/>
              <a:pPr/>
              <a:t>29/1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BA5C5-F6EF-4BDB-9F97-4E8AB2022E6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541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148D7-0B0B-4291-9BEB-1FB0E4031039}" type="datetimeFigureOut">
              <a:rPr lang="en-GB" smtClean="0"/>
              <a:pPr/>
              <a:t>29/1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BA5C5-F6EF-4BDB-9F97-4E8AB2022E6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31189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7148D7-0B0B-4291-9BEB-1FB0E4031039}" type="datetimeFigureOut">
              <a:rPr lang="en-GB" smtClean="0"/>
              <a:pPr/>
              <a:t>29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BBA5C5-F6EF-4BDB-9F97-4E8AB2022E6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76823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5" name="Chart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1790678"/>
              </p:ext>
            </p:extLst>
          </p:nvPr>
        </p:nvGraphicFramePr>
        <p:xfrm>
          <a:off x="165787" y="2413637"/>
          <a:ext cx="3551246" cy="40305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3" name="Chart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5887435"/>
              </p:ext>
            </p:extLst>
          </p:nvPr>
        </p:nvGraphicFramePr>
        <p:xfrm>
          <a:off x="288897" y="550193"/>
          <a:ext cx="3112381" cy="2725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4" name="Rectangle 23"/>
          <p:cNvSpPr/>
          <p:nvPr/>
        </p:nvSpPr>
        <p:spPr>
          <a:xfrm>
            <a:off x="836712" y="791288"/>
            <a:ext cx="360040" cy="1980511"/>
          </a:xfrm>
          <a:prstGeom prst="rect">
            <a:avLst/>
          </a:prstGeom>
          <a:solidFill>
            <a:schemeClr val="bg1">
              <a:lumMod val="65000"/>
              <a:alpha val="28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2"/>
          <p:cNvSpPr>
            <a:spLocks noChangeArrowheads="1"/>
          </p:cNvSpPr>
          <p:nvPr/>
        </p:nvSpPr>
        <p:spPr bwMode="auto">
          <a:xfrm>
            <a:off x="0" y="791289"/>
            <a:ext cx="184731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0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9" name="Rectangle 16"/>
          <p:cNvSpPr>
            <a:spLocks noChangeArrowheads="1"/>
          </p:cNvSpPr>
          <p:nvPr/>
        </p:nvSpPr>
        <p:spPr bwMode="auto">
          <a:xfrm>
            <a:off x="0" y="7192089"/>
            <a:ext cx="184731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-27797" y="6012160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4431874" y="6012160"/>
            <a:ext cx="130035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8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ost Infection</a:t>
            </a:r>
          </a:p>
        </p:txBody>
      </p:sp>
      <p:sp>
        <p:nvSpPr>
          <p:cNvPr id="2" name="Rectangle 1"/>
          <p:cNvSpPr/>
          <p:nvPr/>
        </p:nvSpPr>
        <p:spPr>
          <a:xfrm>
            <a:off x="4508192" y="8763396"/>
            <a:ext cx="130035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8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y Post Infection</a:t>
            </a:r>
          </a:p>
        </p:txBody>
      </p:sp>
      <p:sp>
        <p:nvSpPr>
          <p:cNvPr id="3" name="Rectangle 2"/>
          <p:cNvSpPr/>
          <p:nvPr/>
        </p:nvSpPr>
        <p:spPr>
          <a:xfrm rot="16200000">
            <a:off x="-931026" y="7421465"/>
            <a:ext cx="213712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sexual density / µl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lood (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x10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1229473" y="8763792"/>
            <a:ext cx="130035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8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y Post Infection</a:t>
            </a:r>
          </a:p>
        </p:txBody>
      </p:sp>
      <p:graphicFrame>
        <p:nvGraphicFramePr>
          <p:cNvPr id="35" name="Chart 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83184374"/>
              </p:ext>
            </p:extLst>
          </p:nvPr>
        </p:nvGraphicFramePr>
        <p:xfrm>
          <a:off x="3356993" y="611561"/>
          <a:ext cx="3312368" cy="27874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Rectangle 5"/>
          <p:cNvSpPr/>
          <p:nvPr/>
        </p:nvSpPr>
        <p:spPr>
          <a:xfrm rot="16200000">
            <a:off x="-1041420" y="4556902"/>
            <a:ext cx="23695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Proportion of reticulocytes (% RBC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 rot="16200000">
            <a:off x="-817817" y="1645850"/>
            <a:ext cx="19672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BC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density / ml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lood (x10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8" name="Rectangle 7"/>
          <p:cNvSpPr/>
          <p:nvPr/>
        </p:nvSpPr>
        <p:spPr>
          <a:xfrm>
            <a:off x="1267832" y="3029635"/>
            <a:ext cx="130035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1" i="0" u="none" strike="noStrike" kern="1200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Day Post Infection</a:t>
            </a:r>
          </a:p>
        </p:txBody>
      </p:sp>
      <p:graphicFrame>
        <p:nvGraphicFramePr>
          <p:cNvPr id="39" name="Chart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9486930"/>
              </p:ext>
            </p:extLst>
          </p:nvPr>
        </p:nvGraphicFramePr>
        <p:xfrm>
          <a:off x="3281851" y="3480353"/>
          <a:ext cx="3600400" cy="25411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4" name="Chart 3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53224426"/>
              </p:ext>
            </p:extLst>
          </p:nvPr>
        </p:nvGraphicFramePr>
        <p:xfrm>
          <a:off x="260648" y="6084168"/>
          <a:ext cx="3560982" cy="29886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41" name="Rectangle 40"/>
          <p:cNvSpPr/>
          <p:nvPr/>
        </p:nvSpPr>
        <p:spPr>
          <a:xfrm>
            <a:off x="1229472" y="6012160"/>
            <a:ext cx="130035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8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ost Infection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620688" y="-36512"/>
            <a:ext cx="18362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Cohort 1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44624" y="332820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1" name="Rectangle 30"/>
          <p:cNvSpPr/>
          <p:nvPr/>
        </p:nvSpPr>
        <p:spPr>
          <a:xfrm>
            <a:off x="3933056" y="791289"/>
            <a:ext cx="360040" cy="1980511"/>
          </a:xfrm>
          <a:prstGeom prst="rect">
            <a:avLst/>
          </a:prstGeom>
          <a:solidFill>
            <a:schemeClr val="bg1">
              <a:lumMod val="65000"/>
              <a:alpha val="28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041068" y="-35351"/>
            <a:ext cx="18362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Cohort 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0" y="3203848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6" name="Rectangle 25"/>
          <p:cNvSpPr/>
          <p:nvPr/>
        </p:nvSpPr>
        <p:spPr>
          <a:xfrm>
            <a:off x="836712" y="3635897"/>
            <a:ext cx="360040" cy="2088232"/>
          </a:xfrm>
          <a:prstGeom prst="rect">
            <a:avLst/>
          </a:prstGeom>
          <a:solidFill>
            <a:schemeClr val="bg1">
              <a:lumMod val="65000"/>
              <a:alpha val="28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836712" y="6444208"/>
            <a:ext cx="360040" cy="2160240"/>
          </a:xfrm>
          <a:prstGeom prst="rect">
            <a:avLst/>
          </a:prstGeom>
          <a:solidFill>
            <a:schemeClr val="bg1">
              <a:lumMod val="65000"/>
              <a:alpha val="28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3933056" y="3635896"/>
            <a:ext cx="360040" cy="2088232"/>
          </a:xfrm>
          <a:prstGeom prst="rect">
            <a:avLst/>
          </a:prstGeom>
          <a:solidFill>
            <a:schemeClr val="bg1">
              <a:lumMod val="65000"/>
              <a:alpha val="28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6" name="Chart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03206276"/>
              </p:ext>
            </p:extLst>
          </p:nvPr>
        </p:nvGraphicFramePr>
        <p:xfrm>
          <a:off x="3140968" y="6012160"/>
          <a:ext cx="3717032" cy="29891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37" name="Rectangle 36"/>
          <p:cNvSpPr/>
          <p:nvPr/>
        </p:nvSpPr>
        <p:spPr>
          <a:xfrm>
            <a:off x="3933056" y="6444208"/>
            <a:ext cx="360040" cy="2160240"/>
          </a:xfrm>
          <a:prstGeom prst="rect">
            <a:avLst/>
          </a:prstGeom>
          <a:solidFill>
            <a:schemeClr val="bg1">
              <a:lumMod val="65000"/>
              <a:alpha val="28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4436184" y="8790275"/>
            <a:ext cx="130035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8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y Post Infection</a:t>
            </a:r>
          </a:p>
        </p:txBody>
      </p:sp>
      <p:sp>
        <p:nvSpPr>
          <p:cNvPr id="45" name="Rectangle 44"/>
          <p:cNvSpPr/>
          <p:nvPr/>
        </p:nvSpPr>
        <p:spPr>
          <a:xfrm>
            <a:off x="4724216" y="6012160"/>
            <a:ext cx="130035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8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ost Infection</a:t>
            </a:r>
          </a:p>
        </p:txBody>
      </p:sp>
      <p:sp>
        <p:nvSpPr>
          <p:cNvPr id="46" name="Rectangle 45"/>
          <p:cNvSpPr/>
          <p:nvPr/>
        </p:nvSpPr>
        <p:spPr>
          <a:xfrm>
            <a:off x="4508191" y="3029635"/>
            <a:ext cx="130035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1" i="0" u="none" strike="noStrike" kern="1200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Day Post Infection</a:t>
            </a:r>
          </a:p>
        </p:txBody>
      </p:sp>
      <p:sp>
        <p:nvSpPr>
          <p:cNvPr id="40" name="Rectangle 39"/>
          <p:cNvSpPr/>
          <p:nvPr/>
        </p:nvSpPr>
        <p:spPr>
          <a:xfrm>
            <a:off x="1336556" y="8790275"/>
            <a:ext cx="130035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8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y Post Infection</a:t>
            </a:r>
          </a:p>
        </p:txBody>
      </p:sp>
    </p:spTree>
    <p:extLst>
      <p:ext uri="{BB962C8B-B14F-4D97-AF65-F5344CB8AC3E}">
        <p14:creationId xmlns:p14="http://schemas.microsoft.com/office/powerpoint/2010/main" val="22276123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6126</TotalTime>
  <Words>57</Words>
  <Application>Microsoft Office PowerPoint</Application>
  <PresentationFormat>On-screen Show (4:3)</PresentationFormat>
  <Paragraphs>1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Edinburg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TER Lucy Mary</dc:creator>
  <cp:lastModifiedBy>CARTER Lucy Mary</cp:lastModifiedBy>
  <cp:revision>142</cp:revision>
  <cp:lastPrinted>2013-07-24T09:53:27Z</cp:lastPrinted>
  <dcterms:created xsi:type="dcterms:W3CDTF">2013-07-12T11:24:24Z</dcterms:created>
  <dcterms:modified xsi:type="dcterms:W3CDTF">2013-11-29T15:02:25Z</dcterms:modified>
</cp:coreProperties>
</file>